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1" r:id="rId2"/>
    <p:sldId id="269" r:id="rId3"/>
    <p:sldId id="272" r:id="rId4"/>
    <p:sldId id="270" r:id="rId5"/>
    <p:sldId id="256" r:id="rId6"/>
    <p:sldId id="257" r:id="rId7"/>
    <p:sldId id="258" r:id="rId8"/>
    <p:sldId id="260" r:id="rId9"/>
    <p:sldId id="261" r:id="rId10"/>
    <p:sldId id="259" r:id="rId11"/>
    <p:sldId id="274" r:id="rId12"/>
    <p:sldId id="275" r:id="rId13"/>
    <p:sldId id="276" r:id="rId14"/>
    <p:sldId id="277" r:id="rId1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97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313" autoAdjust="0"/>
    <p:restoredTop sz="94660"/>
  </p:normalViewPr>
  <p:slideViewPr>
    <p:cSldViewPr snapToGrid="0" showGuides="1">
      <p:cViewPr varScale="1">
        <p:scale>
          <a:sx n="59" d="100"/>
          <a:sy n="59" d="100"/>
        </p:scale>
        <p:origin x="2472" y="27"/>
      </p:cViewPr>
      <p:guideLst>
        <p:guide orient="horz" pos="3097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20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laudia Cardenas" userId="e83435a46aeadbaf" providerId="LiveId" clId="{FC2EB1CB-1472-4B1B-A326-0483980B6890}"/>
    <pc:docChg chg="undo custSel modSld sldOrd">
      <pc:chgData name="Claudia Cardenas" userId="e83435a46aeadbaf" providerId="LiveId" clId="{FC2EB1CB-1472-4B1B-A326-0483980B6890}" dt="2023-01-04T11:43:56.002" v="24" actId="20577"/>
      <pc:docMkLst>
        <pc:docMk/>
      </pc:docMkLst>
      <pc:sldChg chg="modSp mod">
        <pc:chgData name="Claudia Cardenas" userId="e83435a46aeadbaf" providerId="LiveId" clId="{FC2EB1CB-1472-4B1B-A326-0483980B6890}" dt="2023-01-04T11:43:18.852" v="8" actId="20577"/>
        <pc:sldMkLst>
          <pc:docMk/>
          <pc:sldMk cId="1589156963" sldId="269"/>
        </pc:sldMkLst>
        <pc:spChg chg="mod">
          <ac:chgData name="Claudia Cardenas" userId="e83435a46aeadbaf" providerId="LiveId" clId="{FC2EB1CB-1472-4B1B-A326-0483980B6890}" dt="2023-01-04T11:43:18.852" v="8" actId="20577"/>
          <ac:spMkLst>
            <pc:docMk/>
            <pc:sldMk cId="1589156963" sldId="269"/>
            <ac:spMk id="2" creationId="{2221405E-B4EE-4ED5-83D3-F0BC58D21F5F}"/>
          </ac:spMkLst>
        </pc:spChg>
      </pc:sldChg>
      <pc:sldChg chg="modSp mod">
        <pc:chgData name="Claudia Cardenas" userId="e83435a46aeadbaf" providerId="LiveId" clId="{FC2EB1CB-1472-4B1B-A326-0483980B6890}" dt="2023-01-04T11:43:35.670" v="14" actId="20577"/>
        <pc:sldMkLst>
          <pc:docMk/>
          <pc:sldMk cId="349826288" sldId="270"/>
        </pc:sldMkLst>
        <pc:spChg chg="mod">
          <ac:chgData name="Claudia Cardenas" userId="e83435a46aeadbaf" providerId="LiveId" clId="{FC2EB1CB-1472-4B1B-A326-0483980B6890}" dt="2023-01-04T11:43:35.670" v="14" actId="20577"/>
          <ac:spMkLst>
            <pc:docMk/>
            <pc:sldMk cId="349826288" sldId="270"/>
            <ac:spMk id="5" creationId="{38644544-17C2-4B6A-A427-C540580F513C}"/>
          </ac:spMkLst>
        </pc:spChg>
      </pc:sldChg>
      <pc:sldChg chg="modSp mod ord">
        <pc:chgData name="Claudia Cardenas" userId="e83435a46aeadbaf" providerId="LiveId" clId="{FC2EB1CB-1472-4B1B-A326-0483980B6890}" dt="2023-01-04T11:43:56.002" v="24" actId="20577"/>
        <pc:sldMkLst>
          <pc:docMk/>
          <pc:sldMk cId="1122460339" sldId="271"/>
        </pc:sldMkLst>
        <pc:spChg chg="mod">
          <ac:chgData name="Claudia Cardenas" userId="e83435a46aeadbaf" providerId="LiveId" clId="{FC2EB1CB-1472-4B1B-A326-0483980B6890}" dt="2023-01-04T11:43:56.002" v="24" actId="20577"/>
          <ac:spMkLst>
            <pc:docMk/>
            <pc:sldMk cId="1122460339" sldId="271"/>
            <ac:spMk id="11" creationId="{F0F3CC20-C7F4-443E-9BCC-3A89352BDB68}"/>
          </ac:spMkLst>
        </pc:spChg>
      </pc:sldChg>
      <pc:sldChg chg="modSp mod">
        <pc:chgData name="Claudia Cardenas" userId="e83435a46aeadbaf" providerId="LiveId" clId="{FC2EB1CB-1472-4B1B-A326-0483980B6890}" dt="2023-01-04T11:43:27.592" v="12" actId="20577"/>
        <pc:sldMkLst>
          <pc:docMk/>
          <pc:sldMk cId="2489548438" sldId="272"/>
        </pc:sldMkLst>
        <pc:spChg chg="mod">
          <ac:chgData name="Claudia Cardenas" userId="e83435a46aeadbaf" providerId="LiveId" clId="{FC2EB1CB-1472-4B1B-A326-0483980B6890}" dt="2023-01-04T11:43:27.592" v="12" actId="20577"/>
          <ac:spMkLst>
            <pc:docMk/>
            <pc:sldMk cId="2489548438" sldId="272"/>
            <ac:spMk id="5" creationId="{22D98EA5-59D8-405C-8799-72E818149E8C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C6A81-04A0-454D-9FE0-A55B4461748D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96E71-CC30-4F9C-B0FD-757E648220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96968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C6A81-04A0-454D-9FE0-A55B4461748D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96E71-CC30-4F9C-B0FD-757E648220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28094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C6A81-04A0-454D-9FE0-A55B4461748D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96E71-CC30-4F9C-B0FD-757E648220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62234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C6A81-04A0-454D-9FE0-A55B4461748D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96E71-CC30-4F9C-B0FD-757E648220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6450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C6A81-04A0-454D-9FE0-A55B4461748D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96E71-CC30-4F9C-B0FD-757E648220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37549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C6A81-04A0-454D-9FE0-A55B4461748D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96E71-CC30-4F9C-B0FD-757E648220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34151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C6A81-04A0-454D-9FE0-A55B4461748D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96E71-CC30-4F9C-B0FD-757E648220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42796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C6A81-04A0-454D-9FE0-A55B4461748D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96E71-CC30-4F9C-B0FD-757E648220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05480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C6A81-04A0-454D-9FE0-A55B4461748D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96E71-CC30-4F9C-B0FD-757E648220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94548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C6A81-04A0-454D-9FE0-A55B4461748D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96E71-CC30-4F9C-B0FD-757E648220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21749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C6A81-04A0-454D-9FE0-A55B4461748D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96E71-CC30-4F9C-B0FD-757E648220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44360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DC6A81-04A0-454D-9FE0-A55B4461748D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496E71-CC30-4F9C-B0FD-757E648220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11401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png"/><Relationship Id="rId13" Type="http://schemas.microsoft.com/office/2007/relationships/hdphoto" Target="../media/hdphoto11.wdp"/><Relationship Id="rId3" Type="http://schemas.openxmlformats.org/officeDocument/2006/relationships/image" Target="../media/image34.png"/><Relationship Id="rId7" Type="http://schemas.microsoft.com/office/2007/relationships/hdphoto" Target="../media/hdphoto8.wdp"/><Relationship Id="rId12" Type="http://schemas.openxmlformats.org/officeDocument/2006/relationships/image" Target="../media/image39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6.png"/><Relationship Id="rId11" Type="http://schemas.microsoft.com/office/2007/relationships/hdphoto" Target="../media/hdphoto10.wdp"/><Relationship Id="rId5" Type="http://schemas.openxmlformats.org/officeDocument/2006/relationships/image" Target="../media/image35.png"/><Relationship Id="rId15" Type="http://schemas.microsoft.com/office/2007/relationships/hdphoto" Target="../media/hdphoto12.wdp"/><Relationship Id="rId10" Type="http://schemas.openxmlformats.org/officeDocument/2006/relationships/image" Target="../media/image38.png"/><Relationship Id="rId4" Type="http://schemas.microsoft.com/office/2007/relationships/hdphoto" Target="../media/hdphoto7.wdp"/><Relationship Id="rId9" Type="http://schemas.microsoft.com/office/2007/relationships/hdphoto" Target="../media/hdphoto9.wdp"/><Relationship Id="rId14" Type="http://schemas.openxmlformats.org/officeDocument/2006/relationships/image" Target="../media/image40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png"/><Relationship Id="rId3" Type="http://schemas.openxmlformats.org/officeDocument/2006/relationships/image" Target="../media/image42.png"/><Relationship Id="rId7" Type="http://schemas.openxmlformats.org/officeDocument/2006/relationships/image" Target="../media/image46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5.png"/><Relationship Id="rId11" Type="http://schemas.openxmlformats.org/officeDocument/2006/relationships/image" Target="../media/image50.png"/><Relationship Id="rId5" Type="http://schemas.openxmlformats.org/officeDocument/2006/relationships/image" Target="../media/image44.png"/><Relationship Id="rId10" Type="http://schemas.openxmlformats.org/officeDocument/2006/relationships/image" Target="../media/image49.png"/><Relationship Id="rId4" Type="http://schemas.openxmlformats.org/officeDocument/2006/relationships/image" Target="../media/image43.png"/><Relationship Id="rId9" Type="http://schemas.openxmlformats.org/officeDocument/2006/relationships/image" Target="../media/image48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7.png"/><Relationship Id="rId3" Type="http://schemas.openxmlformats.org/officeDocument/2006/relationships/image" Target="../media/image52.png"/><Relationship Id="rId7" Type="http://schemas.openxmlformats.org/officeDocument/2006/relationships/image" Target="../media/image56.png"/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5.png"/><Relationship Id="rId11" Type="http://schemas.openxmlformats.org/officeDocument/2006/relationships/image" Target="../media/image60.png"/><Relationship Id="rId5" Type="http://schemas.openxmlformats.org/officeDocument/2006/relationships/image" Target="../media/image54.png"/><Relationship Id="rId10" Type="http://schemas.openxmlformats.org/officeDocument/2006/relationships/image" Target="../media/image59.png"/><Relationship Id="rId4" Type="http://schemas.openxmlformats.org/officeDocument/2006/relationships/image" Target="../media/image53.png"/><Relationship Id="rId9" Type="http://schemas.openxmlformats.org/officeDocument/2006/relationships/image" Target="../media/image58.pn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4.png"/><Relationship Id="rId13" Type="http://schemas.microsoft.com/office/2007/relationships/hdphoto" Target="../media/hdphoto18.wdp"/><Relationship Id="rId18" Type="http://schemas.openxmlformats.org/officeDocument/2006/relationships/image" Target="../media/image69.png"/><Relationship Id="rId3" Type="http://schemas.microsoft.com/office/2007/relationships/hdphoto" Target="../media/hdphoto13.wdp"/><Relationship Id="rId21" Type="http://schemas.microsoft.com/office/2007/relationships/hdphoto" Target="../media/hdphoto22.wdp"/><Relationship Id="rId7" Type="http://schemas.microsoft.com/office/2007/relationships/hdphoto" Target="../media/hdphoto15.wdp"/><Relationship Id="rId12" Type="http://schemas.openxmlformats.org/officeDocument/2006/relationships/image" Target="../media/image66.png"/><Relationship Id="rId17" Type="http://schemas.microsoft.com/office/2007/relationships/hdphoto" Target="../media/hdphoto20.wdp"/><Relationship Id="rId2" Type="http://schemas.openxmlformats.org/officeDocument/2006/relationships/image" Target="../media/image61.png"/><Relationship Id="rId16" Type="http://schemas.openxmlformats.org/officeDocument/2006/relationships/image" Target="../media/image68.png"/><Relationship Id="rId20" Type="http://schemas.openxmlformats.org/officeDocument/2006/relationships/image" Target="../media/image7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3.png"/><Relationship Id="rId11" Type="http://schemas.microsoft.com/office/2007/relationships/hdphoto" Target="../media/hdphoto17.wdp"/><Relationship Id="rId5" Type="http://schemas.microsoft.com/office/2007/relationships/hdphoto" Target="../media/hdphoto14.wdp"/><Relationship Id="rId15" Type="http://schemas.microsoft.com/office/2007/relationships/hdphoto" Target="../media/hdphoto19.wdp"/><Relationship Id="rId10" Type="http://schemas.openxmlformats.org/officeDocument/2006/relationships/image" Target="../media/image65.png"/><Relationship Id="rId19" Type="http://schemas.microsoft.com/office/2007/relationships/hdphoto" Target="../media/hdphoto21.wdp"/><Relationship Id="rId4" Type="http://schemas.openxmlformats.org/officeDocument/2006/relationships/image" Target="../media/image62.png"/><Relationship Id="rId9" Type="http://schemas.microsoft.com/office/2007/relationships/hdphoto" Target="../media/hdphoto16.wdp"/><Relationship Id="rId14" Type="http://schemas.openxmlformats.org/officeDocument/2006/relationships/image" Target="../media/image67.png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74.png"/><Relationship Id="rId13" Type="http://schemas.microsoft.com/office/2007/relationships/hdphoto" Target="../media/hdphoto28.wdp"/><Relationship Id="rId18" Type="http://schemas.openxmlformats.org/officeDocument/2006/relationships/image" Target="../media/image79.png"/><Relationship Id="rId3" Type="http://schemas.microsoft.com/office/2007/relationships/hdphoto" Target="../media/hdphoto23.wdp"/><Relationship Id="rId21" Type="http://schemas.microsoft.com/office/2007/relationships/hdphoto" Target="../media/hdphoto32.wdp"/><Relationship Id="rId7" Type="http://schemas.microsoft.com/office/2007/relationships/hdphoto" Target="../media/hdphoto25.wdp"/><Relationship Id="rId12" Type="http://schemas.openxmlformats.org/officeDocument/2006/relationships/image" Target="../media/image76.png"/><Relationship Id="rId17" Type="http://schemas.microsoft.com/office/2007/relationships/hdphoto" Target="../media/hdphoto30.wdp"/><Relationship Id="rId2" Type="http://schemas.openxmlformats.org/officeDocument/2006/relationships/image" Target="../media/image71.png"/><Relationship Id="rId16" Type="http://schemas.openxmlformats.org/officeDocument/2006/relationships/image" Target="../media/image78.png"/><Relationship Id="rId20" Type="http://schemas.openxmlformats.org/officeDocument/2006/relationships/image" Target="../media/image8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3.png"/><Relationship Id="rId11" Type="http://schemas.microsoft.com/office/2007/relationships/hdphoto" Target="../media/hdphoto27.wdp"/><Relationship Id="rId5" Type="http://schemas.microsoft.com/office/2007/relationships/hdphoto" Target="../media/hdphoto24.wdp"/><Relationship Id="rId15" Type="http://schemas.microsoft.com/office/2007/relationships/hdphoto" Target="../media/hdphoto29.wdp"/><Relationship Id="rId10" Type="http://schemas.openxmlformats.org/officeDocument/2006/relationships/image" Target="../media/image75.png"/><Relationship Id="rId19" Type="http://schemas.microsoft.com/office/2007/relationships/hdphoto" Target="../media/hdphoto31.wdp"/><Relationship Id="rId4" Type="http://schemas.openxmlformats.org/officeDocument/2006/relationships/image" Target="../media/image72.png"/><Relationship Id="rId9" Type="http://schemas.microsoft.com/office/2007/relationships/hdphoto" Target="../media/hdphoto26.wdp"/><Relationship Id="rId14" Type="http://schemas.openxmlformats.org/officeDocument/2006/relationships/image" Target="../media/image77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png"/><Relationship Id="rId11" Type="http://schemas.openxmlformats.org/officeDocument/2006/relationships/image" Target="../media/image14.png"/><Relationship Id="rId5" Type="http://schemas.openxmlformats.org/officeDocument/2006/relationships/image" Target="../media/image8.png"/><Relationship Id="rId10" Type="http://schemas.openxmlformats.org/officeDocument/2006/relationships/image" Target="../media/image13.png"/><Relationship Id="rId4" Type="http://schemas.openxmlformats.org/officeDocument/2006/relationships/image" Target="../media/image7.png"/><Relationship Id="rId9" Type="http://schemas.openxmlformats.org/officeDocument/2006/relationships/image" Target="../media/image12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9.png"/><Relationship Id="rId11" Type="http://schemas.openxmlformats.org/officeDocument/2006/relationships/image" Target="../media/image24.png"/><Relationship Id="rId5" Type="http://schemas.openxmlformats.org/officeDocument/2006/relationships/image" Target="../media/image18.png"/><Relationship Id="rId10" Type="http://schemas.openxmlformats.org/officeDocument/2006/relationships/image" Target="../media/image23.png"/><Relationship Id="rId4" Type="http://schemas.openxmlformats.org/officeDocument/2006/relationships/image" Target="../media/image17.png"/><Relationship Id="rId9" Type="http://schemas.openxmlformats.org/officeDocument/2006/relationships/image" Target="../media/image22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13" Type="http://schemas.microsoft.com/office/2007/relationships/hdphoto" Target="../media/hdphoto5.wdp"/><Relationship Id="rId3" Type="http://schemas.openxmlformats.org/officeDocument/2006/relationships/image" Target="../media/image26.png"/><Relationship Id="rId7" Type="http://schemas.microsoft.com/office/2007/relationships/hdphoto" Target="../media/hdphoto2.wdp"/><Relationship Id="rId12" Type="http://schemas.openxmlformats.org/officeDocument/2006/relationships/image" Target="../media/image31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8.png"/><Relationship Id="rId11" Type="http://schemas.microsoft.com/office/2007/relationships/hdphoto" Target="../media/hdphoto4.wdp"/><Relationship Id="rId5" Type="http://schemas.microsoft.com/office/2007/relationships/hdphoto" Target="../media/hdphoto1.wdp"/><Relationship Id="rId15" Type="http://schemas.microsoft.com/office/2007/relationships/hdphoto" Target="../media/hdphoto6.wdp"/><Relationship Id="rId10" Type="http://schemas.openxmlformats.org/officeDocument/2006/relationships/image" Target="../media/image30.png"/><Relationship Id="rId4" Type="http://schemas.openxmlformats.org/officeDocument/2006/relationships/image" Target="../media/image27.png"/><Relationship Id="rId9" Type="http://schemas.microsoft.com/office/2007/relationships/hdphoto" Target="../media/hdphoto3.wdp"/><Relationship Id="rId14" Type="http://schemas.openxmlformats.org/officeDocument/2006/relationships/image" Target="../media/image3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>
            <a:extLst>
              <a:ext uri="{FF2B5EF4-FFF2-40B4-BE49-F238E27FC236}">
                <a16:creationId xmlns:a16="http://schemas.microsoft.com/office/drawing/2014/main" id="{F0F3CC20-C7F4-443E-9BCC-3A89352BDB68}"/>
              </a:ext>
            </a:extLst>
          </p:cNvPr>
          <p:cNvSpPr/>
          <p:nvPr/>
        </p:nvSpPr>
        <p:spPr>
          <a:xfrm>
            <a:off x="1371599" y="881839"/>
            <a:ext cx="4554818" cy="7793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GB" sz="1200" b="1" dirty="0">
                <a:solidFill>
                  <a:srgbClr val="1C1D1E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Table S</a:t>
            </a:r>
            <a:r>
              <a:rPr lang="en-US" sz="1200" b="1" dirty="0">
                <a:solidFill>
                  <a:srgbClr val="1C1D1E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1</a:t>
            </a:r>
            <a:r>
              <a:rPr lang="en-GB" sz="1200" b="1" dirty="0">
                <a:solidFill>
                  <a:srgbClr val="1C1D1E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r>
              <a:rPr lang="en-US" sz="1200" dirty="0">
                <a:solidFill>
                  <a:srgbClr val="1C1D1E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Proteins differentially regulated in </a:t>
            </a:r>
            <a:r>
              <a:rPr lang="et-EE" sz="1200" dirty="0">
                <a:solidFill>
                  <a:srgbClr val="1C1D1E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DC</a:t>
            </a:r>
            <a:r>
              <a:rPr lang="en-US" sz="1200" dirty="0">
                <a:solidFill>
                  <a:srgbClr val="1C1D1E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vs control samples.</a:t>
            </a:r>
            <a:r>
              <a:rPr lang="et-EE" sz="1200" dirty="0">
                <a:solidFill>
                  <a:srgbClr val="1C1D1E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As a </a:t>
            </a:r>
            <a:r>
              <a:rPr lang="et-EE" sz="1200" dirty="0" err="1">
                <a:solidFill>
                  <a:srgbClr val="1C1D1E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separate</a:t>
            </a:r>
            <a:r>
              <a:rPr lang="et-EE" sz="1200" dirty="0">
                <a:solidFill>
                  <a:srgbClr val="1C1D1E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 Excel </a:t>
            </a:r>
            <a:r>
              <a:rPr lang="et-EE" sz="1200" dirty="0" err="1">
                <a:solidFill>
                  <a:srgbClr val="1C1D1E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ile</a:t>
            </a:r>
            <a:r>
              <a:rPr lang="et-EE" sz="1200" dirty="0">
                <a:solidFill>
                  <a:srgbClr val="1C1D1E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  <a:endParaRPr lang="en-GB" sz="1200" dirty="0"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246033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>
            <a:extLst>
              <a:ext uri="{FF2B5EF4-FFF2-40B4-BE49-F238E27FC236}">
                <a16:creationId xmlns:a16="http://schemas.microsoft.com/office/drawing/2014/main" id="{7739033F-886F-41E0-A2AB-DADE5193F689}"/>
              </a:ext>
            </a:extLst>
          </p:cNvPr>
          <p:cNvSpPr txBox="1"/>
          <p:nvPr/>
        </p:nvSpPr>
        <p:spPr>
          <a:xfrm>
            <a:off x="2443187" y="632323"/>
            <a:ext cx="7251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400" dirty="0"/>
              <a:t>Control</a:t>
            </a:r>
            <a:endParaRPr lang="en-GB" sz="14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7CF5D2C-9041-4899-B629-9A9D02471DBB}"/>
              </a:ext>
            </a:extLst>
          </p:cNvPr>
          <p:cNvSpPr txBox="1"/>
          <p:nvPr/>
        </p:nvSpPr>
        <p:spPr>
          <a:xfrm>
            <a:off x="4772279" y="632322"/>
            <a:ext cx="3914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400" dirty="0"/>
              <a:t>DC</a:t>
            </a:r>
            <a:endParaRPr lang="en-GB" sz="14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AFF1456-BAF0-4A22-A1FC-B366ACE266D2}"/>
              </a:ext>
            </a:extLst>
          </p:cNvPr>
          <p:cNvSpPr txBox="1"/>
          <p:nvPr/>
        </p:nvSpPr>
        <p:spPr>
          <a:xfrm>
            <a:off x="897053" y="1563294"/>
            <a:ext cx="5346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400" dirty="0"/>
              <a:t>DAPI</a:t>
            </a:r>
            <a:endParaRPr lang="en-GB" sz="14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0E2B80A-692A-4D55-A4F1-FBBD662CF8A7}"/>
              </a:ext>
            </a:extLst>
          </p:cNvPr>
          <p:cNvSpPr txBox="1"/>
          <p:nvPr/>
        </p:nvSpPr>
        <p:spPr>
          <a:xfrm>
            <a:off x="707588" y="6592633"/>
            <a:ext cx="7562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400" dirty="0" err="1"/>
              <a:t>Merged</a:t>
            </a:r>
            <a:endParaRPr lang="en-GB" sz="14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786807C-4F97-45C0-A418-CEDDA5E1C807}"/>
              </a:ext>
            </a:extLst>
          </p:cNvPr>
          <p:cNvSpPr txBox="1"/>
          <p:nvPr/>
        </p:nvSpPr>
        <p:spPr>
          <a:xfrm>
            <a:off x="897053" y="4953000"/>
            <a:ext cx="5389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t-EE" sz="1400" dirty="0"/>
              <a:t>K15</a:t>
            </a:r>
            <a:endParaRPr lang="en-GB" sz="14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B29AE9E-566F-416B-B171-7C1FBABEDE9A}"/>
              </a:ext>
            </a:extLst>
          </p:cNvPr>
          <p:cNvSpPr txBox="1"/>
          <p:nvPr/>
        </p:nvSpPr>
        <p:spPr>
          <a:xfrm>
            <a:off x="814162" y="3161950"/>
            <a:ext cx="5068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400" dirty="0"/>
              <a:t>DCN</a:t>
            </a:r>
            <a:endParaRPr lang="en-GB" sz="1400" dirty="0"/>
          </a:p>
        </p:txBody>
      </p:sp>
      <p:pic>
        <p:nvPicPr>
          <p:cNvPr id="69" name="Picture 68">
            <a:extLst>
              <a:ext uri="{FF2B5EF4-FFF2-40B4-BE49-F238E27FC236}">
                <a16:creationId xmlns:a16="http://schemas.microsoft.com/office/drawing/2014/main" id="{1EB56946-F781-45DD-B6BE-E681808FCBC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66049" y="887705"/>
            <a:ext cx="2158171" cy="1646063"/>
          </a:xfrm>
          <a:prstGeom prst="rect">
            <a:avLst/>
          </a:prstGeom>
        </p:spPr>
      </p:pic>
      <p:pic>
        <p:nvPicPr>
          <p:cNvPr id="73" name="Picture 72">
            <a:extLst>
              <a:ext uri="{FF2B5EF4-FFF2-40B4-BE49-F238E27FC236}">
                <a16:creationId xmlns:a16="http://schemas.microsoft.com/office/drawing/2014/main" id="{98F54B1E-39B2-4A6E-91E5-2C48E7B2BC8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666050" y="2568030"/>
            <a:ext cx="2158171" cy="1646063"/>
          </a:xfrm>
          <a:prstGeom prst="rect">
            <a:avLst/>
          </a:prstGeom>
        </p:spPr>
      </p:pic>
      <p:pic>
        <p:nvPicPr>
          <p:cNvPr id="75" name="Picture 74">
            <a:extLst>
              <a:ext uri="{FF2B5EF4-FFF2-40B4-BE49-F238E27FC236}">
                <a16:creationId xmlns:a16="http://schemas.microsoft.com/office/drawing/2014/main" id="{035FF266-888B-4EDE-B97C-3B66EC62222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66049" y="4242362"/>
            <a:ext cx="2158171" cy="1646063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DC2613D5-4A54-48C3-A68E-42098048457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001488" y="4243969"/>
            <a:ext cx="2158171" cy="1646063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BE065FC7-14C8-4ADB-9AB4-FFA9249E05E1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001488" y="881646"/>
            <a:ext cx="2158171" cy="1646063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E0B41135-2DFD-45C6-8EE5-6F5A46895655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001488" y="5934700"/>
            <a:ext cx="2158171" cy="1646063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B3B8CA87-6FE9-4E96-9CD2-7AD608AF535C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001487" y="2559335"/>
            <a:ext cx="2158171" cy="1639966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0EC23CC9-C4BF-49DA-9500-CD189F179028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666048" y="5934699"/>
            <a:ext cx="2158171" cy="1646063"/>
          </a:xfrm>
          <a:prstGeom prst="rect">
            <a:avLst/>
          </a:prstGeom>
        </p:spPr>
      </p:pic>
      <p:sp>
        <p:nvSpPr>
          <p:cNvPr id="16" name="Rectangle 15">
            <a:extLst>
              <a:ext uri="{FF2B5EF4-FFF2-40B4-BE49-F238E27FC236}">
                <a16:creationId xmlns:a16="http://schemas.microsoft.com/office/drawing/2014/main" id="{392A66B5-782F-4189-84B6-15F3B10C7BF2}"/>
              </a:ext>
            </a:extLst>
          </p:cNvPr>
          <p:cNvSpPr/>
          <p:nvPr/>
        </p:nvSpPr>
        <p:spPr>
          <a:xfrm>
            <a:off x="586872" y="8711942"/>
            <a:ext cx="5684256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t-EE" sz="11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</a:t>
            </a:r>
            <a:r>
              <a:rPr lang="et-EE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6. 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ative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crographs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f Control and DC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amples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ained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ith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API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ecorin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DCN) and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ytokeratin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15 (K15) are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own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cale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ar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s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50 µm.</a:t>
            </a:r>
            <a:r>
              <a:rPr lang="et-EE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en-GB" sz="1100" dirty="0"/>
          </a:p>
        </p:txBody>
      </p:sp>
    </p:spTree>
    <p:extLst>
      <p:ext uri="{BB962C8B-B14F-4D97-AF65-F5344CB8AC3E}">
        <p14:creationId xmlns:p14="http://schemas.microsoft.com/office/powerpoint/2010/main" val="358035102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>
            <a:extLst>
              <a:ext uri="{FF2B5EF4-FFF2-40B4-BE49-F238E27FC236}">
                <a16:creationId xmlns:a16="http://schemas.microsoft.com/office/drawing/2014/main" id="{7739033F-886F-41E0-A2AB-DADE5193F689}"/>
              </a:ext>
            </a:extLst>
          </p:cNvPr>
          <p:cNvSpPr txBox="1"/>
          <p:nvPr/>
        </p:nvSpPr>
        <p:spPr>
          <a:xfrm>
            <a:off x="2443187" y="632323"/>
            <a:ext cx="7251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400" dirty="0"/>
              <a:t>Control</a:t>
            </a:r>
            <a:endParaRPr lang="en-GB" sz="14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7CF5D2C-9041-4899-B629-9A9D02471DBB}"/>
              </a:ext>
            </a:extLst>
          </p:cNvPr>
          <p:cNvSpPr txBox="1"/>
          <p:nvPr/>
        </p:nvSpPr>
        <p:spPr>
          <a:xfrm>
            <a:off x="4394800" y="632322"/>
            <a:ext cx="3914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400" dirty="0"/>
              <a:t>DC</a:t>
            </a:r>
            <a:endParaRPr lang="en-GB" sz="1400" dirty="0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392A66B5-782F-4189-84B6-15F3B10C7BF2}"/>
              </a:ext>
            </a:extLst>
          </p:cNvPr>
          <p:cNvSpPr/>
          <p:nvPr/>
        </p:nvSpPr>
        <p:spPr>
          <a:xfrm>
            <a:off x="586872" y="8711942"/>
            <a:ext cx="5684256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t-EE" sz="11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</a:t>
            </a:r>
            <a:r>
              <a:rPr lang="et-EE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7. 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ative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crographs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f Control and DC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amples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ained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ith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API,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imentin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VIM), collagen-4 (COL4), and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mooth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uscle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ctin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SMA) are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own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cale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ar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s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200 µm.</a:t>
            </a:r>
            <a:r>
              <a:rPr lang="et-EE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en-GB" sz="1100" dirty="0"/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6149B11B-BF0E-451D-9759-D3A203040079}"/>
              </a:ext>
            </a:extLst>
          </p:cNvPr>
          <p:cNvGrpSpPr/>
          <p:nvPr/>
        </p:nvGrpSpPr>
        <p:grpSpPr>
          <a:xfrm>
            <a:off x="1900581" y="940099"/>
            <a:ext cx="3578197" cy="6930850"/>
            <a:chOff x="916864" y="835292"/>
            <a:chExt cx="4346955" cy="8332253"/>
          </a:xfrm>
        </p:grpSpPr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23DDA847-2641-435F-B8CD-EF6865213FB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22961" y="835292"/>
              <a:ext cx="2158171" cy="1646063"/>
            </a:xfrm>
            <a:prstGeom prst="rect">
              <a:avLst/>
            </a:prstGeom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603DB4B0-32B5-4F28-946A-9BDA212CE30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22961" y="2508392"/>
              <a:ext cx="2158171" cy="1646063"/>
            </a:xfrm>
            <a:prstGeom prst="rect">
              <a:avLst/>
            </a:prstGeom>
          </p:spPr>
        </p:pic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1DBE1D6D-D946-432F-8137-FEF2BA9B81C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16864" y="4181493"/>
              <a:ext cx="2164268" cy="1646063"/>
            </a:xfrm>
            <a:prstGeom prst="rect">
              <a:avLst/>
            </a:prstGeom>
          </p:spPr>
        </p:pic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9BDB0BAF-1E93-418F-A39C-F95F27414DD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922961" y="5855842"/>
              <a:ext cx="2158171" cy="1646063"/>
            </a:xfrm>
            <a:prstGeom prst="rect">
              <a:avLst/>
            </a:prstGeom>
          </p:spPr>
        </p:pic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6BA2F5A7-C898-4691-A0D1-3F43A4E8D7F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922961" y="7521482"/>
              <a:ext cx="2158171" cy="1646063"/>
            </a:xfrm>
            <a:prstGeom prst="rect">
              <a:avLst/>
            </a:prstGeom>
          </p:spPr>
        </p:pic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D9A4374D-92DA-4C6C-8BE9-C912C311B94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105648" y="835292"/>
              <a:ext cx="2158171" cy="1646063"/>
            </a:xfrm>
            <a:prstGeom prst="rect">
              <a:avLst/>
            </a:prstGeom>
          </p:spPr>
        </p:pic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346B3733-5CA8-4F38-9E6B-7EE8AEE8EF4B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105647" y="2507144"/>
              <a:ext cx="2158171" cy="1646063"/>
            </a:xfrm>
            <a:prstGeom prst="rect">
              <a:avLst/>
            </a:prstGeom>
          </p:spPr>
        </p:pic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8A872229-CB00-4E27-9314-8063659F58BD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105647" y="4181493"/>
              <a:ext cx="2158171" cy="1646063"/>
            </a:xfrm>
            <a:prstGeom prst="rect">
              <a:avLst/>
            </a:prstGeom>
          </p:spPr>
        </p:pic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B3831C4C-DEC2-4010-AA12-399A9B7EDB15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105647" y="5849436"/>
              <a:ext cx="2158171" cy="1646063"/>
            </a:xfrm>
            <a:prstGeom prst="rect">
              <a:avLst/>
            </a:prstGeom>
          </p:spPr>
        </p:pic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9BABBB97-AAFD-4FE6-AAC5-0281E36D0139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105647" y="7521481"/>
              <a:ext cx="2158171" cy="1646063"/>
            </a:xfrm>
            <a:prstGeom prst="rect">
              <a:avLst/>
            </a:prstGeom>
          </p:spPr>
        </p:pic>
      </p:grpSp>
      <p:sp>
        <p:nvSpPr>
          <p:cNvPr id="44" name="TextBox 43">
            <a:extLst>
              <a:ext uri="{FF2B5EF4-FFF2-40B4-BE49-F238E27FC236}">
                <a16:creationId xmlns:a16="http://schemas.microsoft.com/office/drawing/2014/main" id="{448D66E6-9B2B-475B-B12F-51F3A72C56DF}"/>
              </a:ext>
            </a:extLst>
          </p:cNvPr>
          <p:cNvSpPr txBox="1"/>
          <p:nvPr/>
        </p:nvSpPr>
        <p:spPr>
          <a:xfrm>
            <a:off x="1143071" y="1449284"/>
            <a:ext cx="485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200" dirty="0"/>
              <a:t>DAPI</a:t>
            </a:r>
            <a:endParaRPr lang="en-GB" sz="12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9CC77DDC-43B3-4CF6-9ACE-22C45CD7134C}"/>
              </a:ext>
            </a:extLst>
          </p:cNvPr>
          <p:cNvSpPr txBox="1"/>
          <p:nvPr/>
        </p:nvSpPr>
        <p:spPr>
          <a:xfrm>
            <a:off x="1290048" y="6927479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200" dirty="0"/>
              <a:t>M</a:t>
            </a:r>
            <a:endParaRPr lang="en-GB" sz="1200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A0CED235-B43B-450B-B0F4-04A47FD25435}"/>
              </a:ext>
            </a:extLst>
          </p:cNvPr>
          <p:cNvSpPr txBox="1"/>
          <p:nvPr/>
        </p:nvSpPr>
        <p:spPr>
          <a:xfrm>
            <a:off x="1179482" y="5554414"/>
            <a:ext cx="11644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t-EE" sz="1200" dirty="0"/>
              <a:t>SMA</a:t>
            </a:r>
            <a:endParaRPr lang="en-GB" sz="12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C8F1CB0B-9C45-4DAF-9C7C-CBBCDB8ED463}"/>
              </a:ext>
            </a:extLst>
          </p:cNvPr>
          <p:cNvSpPr txBox="1"/>
          <p:nvPr/>
        </p:nvSpPr>
        <p:spPr>
          <a:xfrm>
            <a:off x="1145511" y="4042849"/>
            <a:ext cx="5103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200" dirty="0"/>
              <a:t>COL4</a:t>
            </a:r>
            <a:endParaRPr lang="en-GB" sz="12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23EFCB1D-3051-4226-93CE-9170666DC25B}"/>
              </a:ext>
            </a:extLst>
          </p:cNvPr>
          <p:cNvSpPr txBox="1"/>
          <p:nvPr/>
        </p:nvSpPr>
        <p:spPr>
          <a:xfrm>
            <a:off x="1151909" y="2835948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200" dirty="0"/>
              <a:t>VIM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223636321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>
            <a:extLst>
              <a:ext uri="{FF2B5EF4-FFF2-40B4-BE49-F238E27FC236}">
                <a16:creationId xmlns:a16="http://schemas.microsoft.com/office/drawing/2014/main" id="{7739033F-886F-41E0-A2AB-DADE5193F689}"/>
              </a:ext>
            </a:extLst>
          </p:cNvPr>
          <p:cNvSpPr txBox="1"/>
          <p:nvPr/>
        </p:nvSpPr>
        <p:spPr>
          <a:xfrm>
            <a:off x="2271442" y="632324"/>
            <a:ext cx="7251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400" dirty="0"/>
              <a:t>Control</a:t>
            </a:r>
            <a:endParaRPr lang="en-GB" sz="14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7CF5D2C-9041-4899-B629-9A9D02471DBB}"/>
              </a:ext>
            </a:extLst>
          </p:cNvPr>
          <p:cNvSpPr txBox="1"/>
          <p:nvPr/>
        </p:nvSpPr>
        <p:spPr>
          <a:xfrm>
            <a:off x="4249973" y="585463"/>
            <a:ext cx="3914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400" dirty="0"/>
              <a:t>DC</a:t>
            </a:r>
            <a:endParaRPr lang="en-GB" sz="14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A95E18E-054A-4755-9BD6-44A9FA6F1E3E}"/>
              </a:ext>
            </a:extLst>
          </p:cNvPr>
          <p:cNvSpPr txBox="1"/>
          <p:nvPr/>
        </p:nvSpPr>
        <p:spPr>
          <a:xfrm>
            <a:off x="1143071" y="1449284"/>
            <a:ext cx="485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200" dirty="0"/>
              <a:t>DAPI</a:t>
            </a:r>
            <a:endParaRPr lang="en-GB" sz="12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ABA4054-229C-4379-AA7F-FABCE4E0F71C}"/>
              </a:ext>
            </a:extLst>
          </p:cNvPr>
          <p:cNvSpPr txBox="1"/>
          <p:nvPr/>
        </p:nvSpPr>
        <p:spPr>
          <a:xfrm>
            <a:off x="1290048" y="6927479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200" dirty="0"/>
              <a:t>M</a:t>
            </a:r>
            <a:endParaRPr lang="en-GB" sz="12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4DC2252-DF8E-4AAB-90E4-ABDC6EAF0382}"/>
              </a:ext>
            </a:extLst>
          </p:cNvPr>
          <p:cNvSpPr txBox="1"/>
          <p:nvPr/>
        </p:nvSpPr>
        <p:spPr>
          <a:xfrm>
            <a:off x="1179482" y="5554414"/>
            <a:ext cx="11644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t-EE" sz="1200" dirty="0"/>
              <a:t>SMA</a:t>
            </a:r>
            <a:endParaRPr lang="en-GB" sz="12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BD99B77-2F6F-46DD-8C20-A9B3478EEADF}"/>
              </a:ext>
            </a:extLst>
          </p:cNvPr>
          <p:cNvSpPr txBox="1"/>
          <p:nvPr/>
        </p:nvSpPr>
        <p:spPr>
          <a:xfrm>
            <a:off x="1145511" y="4042849"/>
            <a:ext cx="5103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200" dirty="0"/>
              <a:t>COL4</a:t>
            </a:r>
            <a:endParaRPr lang="en-GB" sz="12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0011CDA-9AB2-4771-B73E-2F263FB6A377}"/>
              </a:ext>
            </a:extLst>
          </p:cNvPr>
          <p:cNvSpPr txBox="1"/>
          <p:nvPr/>
        </p:nvSpPr>
        <p:spPr>
          <a:xfrm>
            <a:off x="1151909" y="2835948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200" dirty="0"/>
              <a:t>VIM</a:t>
            </a:r>
            <a:endParaRPr lang="en-GB" sz="1200" dirty="0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CF128D23-98F7-4F9A-9EF0-F8B2FB51B0F3}"/>
              </a:ext>
            </a:extLst>
          </p:cNvPr>
          <p:cNvSpPr/>
          <p:nvPr/>
        </p:nvSpPr>
        <p:spPr>
          <a:xfrm>
            <a:off x="586872" y="8711942"/>
            <a:ext cx="5684256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t-EE" sz="11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</a:t>
            </a:r>
            <a:r>
              <a:rPr lang="et-EE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8. 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ative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crographs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f Control and DC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amples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ained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ith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API,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imentin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VIM), collagen-4 (COL4), and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mooth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uscle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ctin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SMA) are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own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cale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ar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s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50 µm.</a:t>
            </a:r>
            <a:r>
              <a:rPr lang="et-EE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en-GB" sz="1100" dirty="0"/>
          </a:p>
        </p:txBody>
      </p:sp>
      <p:grpSp>
        <p:nvGrpSpPr>
          <p:cNvPr id="35" name="Group 34">
            <a:extLst>
              <a:ext uri="{FF2B5EF4-FFF2-40B4-BE49-F238E27FC236}">
                <a16:creationId xmlns:a16="http://schemas.microsoft.com/office/drawing/2014/main" id="{2EB66BBB-9A0B-4EB8-9E88-9118174C67C7}"/>
              </a:ext>
            </a:extLst>
          </p:cNvPr>
          <p:cNvGrpSpPr/>
          <p:nvPr/>
        </p:nvGrpSpPr>
        <p:grpSpPr>
          <a:xfrm>
            <a:off x="1826076" y="888700"/>
            <a:ext cx="3582444" cy="7097151"/>
            <a:chOff x="929132" y="906025"/>
            <a:chExt cx="3582444" cy="7097151"/>
          </a:xfrm>
        </p:grpSpPr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3C1A82AD-9C13-4A8A-8CDF-2E7FD7AB1F1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37445" y="2325211"/>
              <a:ext cx="1776999" cy="1404000"/>
            </a:xfrm>
            <a:prstGeom prst="rect">
              <a:avLst/>
            </a:prstGeom>
          </p:spPr>
        </p:pic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id="{2CE8D137-0194-483A-89A5-6AB3514C8191}"/>
                </a:ext>
              </a:extLst>
            </p:cNvPr>
            <p:cNvGrpSpPr/>
            <p:nvPr/>
          </p:nvGrpSpPr>
          <p:grpSpPr>
            <a:xfrm>
              <a:off x="929132" y="906025"/>
              <a:ext cx="3582444" cy="7097151"/>
              <a:chOff x="929132" y="906025"/>
              <a:chExt cx="3582444" cy="7097151"/>
            </a:xfrm>
          </p:grpSpPr>
          <p:grpSp>
            <p:nvGrpSpPr>
              <p:cNvPr id="38" name="Group 37">
                <a:extLst>
                  <a:ext uri="{FF2B5EF4-FFF2-40B4-BE49-F238E27FC236}">
                    <a16:creationId xmlns:a16="http://schemas.microsoft.com/office/drawing/2014/main" id="{2BF91912-B2F0-4089-AF3E-31DB43F688BA}"/>
                  </a:ext>
                </a:extLst>
              </p:cNvPr>
              <p:cNvGrpSpPr/>
              <p:nvPr/>
            </p:nvGrpSpPr>
            <p:grpSpPr>
              <a:xfrm>
                <a:off x="936066" y="906025"/>
                <a:ext cx="3575510" cy="7097151"/>
                <a:chOff x="873426" y="722868"/>
                <a:chExt cx="4342469" cy="8326505"/>
              </a:xfrm>
            </p:grpSpPr>
            <p:pic>
              <p:nvPicPr>
                <p:cNvPr id="40" name="Picture 39">
                  <a:extLst>
                    <a:ext uri="{FF2B5EF4-FFF2-40B4-BE49-F238E27FC236}">
                      <a16:creationId xmlns:a16="http://schemas.microsoft.com/office/drawing/2014/main" id="{EA55CDC9-0546-41D6-A7A2-A73657E498F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873426" y="726545"/>
                  <a:ext cx="2164268" cy="1646063"/>
                </a:xfrm>
                <a:prstGeom prst="rect">
                  <a:avLst/>
                </a:prstGeom>
              </p:spPr>
            </p:pic>
            <p:pic>
              <p:nvPicPr>
                <p:cNvPr id="41" name="Picture 40">
                  <a:extLst>
                    <a:ext uri="{FF2B5EF4-FFF2-40B4-BE49-F238E27FC236}">
                      <a16:creationId xmlns:a16="http://schemas.microsoft.com/office/drawing/2014/main" id="{83620BED-EC03-4703-BC7C-31AA40DF5E7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876474" y="4066436"/>
                  <a:ext cx="2158171" cy="1646063"/>
                </a:xfrm>
                <a:prstGeom prst="rect">
                  <a:avLst/>
                </a:prstGeom>
              </p:spPr>
            </p:pic>
            <p:pic>
              <p:nvPicPr>
                <p:cNvPr id="42" name="Picture 41">
                  <a:extLst>
                    <a:ext uri="{FF2B5EF4-FFF2-40B4-BE49-F238E27FC236}">
                      <a16:creationId xmlns:a16="http://schemas.microsoft.com/office/drawing/2014/main" id="{316AD41E-0341-4DAE-8EA2-32190610736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873426" y="5739982"/>
                  <a:ext cx="2158171" cy="1646063"/>
                </a:xfrm>
                <a:prstGeom prst="rect">
                  <a:avLst/>
                </a:prstGeom>
              </p:spPr>
            </p:pic>
            <p:pic>
              <p:nvPicPr>
                <p:cNvPr id="43" name="Picture 42">
                  <a:extLst>
                    <a:ext uri="{FF2B5EF4-FFF2-40B4-BE49-F238E27FC236}">
                      <a16:creationId xmlns:a16="http://schemas.microsoft.com/office/drawing/2014/main" id="{6CF76F1D-730D-4352-AF9B-C28AA830AFD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3057724" y="722868"/>
                  <a:ext cx="2158171" cy="1646063"/>
                </a:xfrm>
                <a:prstGeom prst="rect">
                  <a:avLst/>
                </a:prstGeom>
              </p:spPr>
            </p:pic>
            <p:pic>
              <p:nvPicPr>
                <p:cNvPr id="44" name="Picture 43">
                  <a:extLst>
                    <a:ext uri="{FF2B5EF4-FFF2-40B4-BE49-F238E27FC236}">
                      <a16:creationId xmlns:a16="http://schemas.microsoft.com/office/drawing/2014/main" id="{73EE51FF-3086-45D8-8C88-55917FDBFDA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3057724" y="2382673"/>
                  <a:ext cx="2158171" cy="1646063"/>
                </a:xfrm>
                <a:prstGeom prst="rect">
                  <a:avLst/>
                </a:prstGeom>
              </p:spPr>
            </p:pic>
            <p:pic>
              <p:nvPicPr>
                <p:cNvPr id="45" name="Picture 44">
                  <a:extLst>
                    <a:ext uri="{FF2B5EF4-FFF2-40B4-BE49-F238E27FC236}">
                      <a16:creationId xmlns:a16="http://schemas.microsoft.com/office/drawing/2014/main" id="{2D372FDC-E9EC-417D-B3C1-CDC149FCEA0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3057724" y="4056218"/>
                  <a:ext cx="2158171" cy="1646063"/>
                </a:xfrm>
                <a:prstGeom prst="rect">
                  <a:avLst/>
                </a:prstGeom>
              </p:spPr>
            </p:pic>
            <p:pic>
              <p:nvPicPr>
                <p:cNvPr id="46" name="Picture 45">
                  <a:extLst>
                    <a:ext uri="{FF2B5EF4-FFF2-40B4-BE49-F238E27FC236}">
                      <a16:creationId xmlns:a16="http://schemas.microsoft.com/office/drawing/2014/main" id="{D1C00EAD-6812-42AB-8AF2-63E5F6C38F3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3057724" y="5729765"/>
                  <a:ext cx="2158171" cy="1646063"/>
                </a:xfrm>
                <a:prstGeom prst="rect">
                  <a:avLst/>
                </a:prstGeom>
              </p:spPr>
            </p:pic>
            <p:pic>
              <p:nvPicPr>
                <p:cNvPr id="48" name="Picture 47">
                  <a:extLst>
                    <a:ext uri="{FF2B5EF4-FFF2-40B4-BE49-F238E27FC236}">
                      <a16:creationId xmlns:a16="http://schemas.microsoft.com/office/drawing/2014/main" id="{616C2E22-427F-4B6D-83B6-C0EA76B737F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/>
                <a:stretch>
                  <a:fillRect/>
                </a:stretch>
              </p:blipFill>
              <p:spPr>
                <a:xfrm>
                  <a:off x="3057724" y="7403310"/>
                  <a:ext cx="2158171" cy="1646063"/>
                </a:xfrm>
                <a:prstGeom prst="rect">
                  <a:avLst/>
                </a:prstGeom>
              </p:spPr>
            </p:pic>
          </p:grpSp>
          <p:pic>
            <p:nvPicPr>
              <p:cNvPr id="39" name="Picture 38">
                <a:extLst>
                  <a:ext uri="{FF2B5EF4-FFF2-40B4-BE49-F238E27FC236}">
                    <a16:creationId xmlns:a16="http://schemas.microsoft.com/office/drawing/2014/main" id="{D3D189CD-5735-40FF-BBB1-321BF72CF96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929132" y="6599176"/>
                <a:ext cx="1776999" cy="1404000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36789178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ctangle 13">
            <a:extLst>
              <a:ext uri="{FF2B5EF4-FFF2-40B4-BE49-F238E27FC236}">
                <a16:creationId xmlns:a16="http://schemas.microsoft.com/office/drawing/2014/main" id="{14E0A028-CA21-4ED5-9EE4-CAEDA3C6FD43}"/>
              </a:ext>
            </a:extLst>
          </p:cNvPr>
          <p:cNvSpPr/>
          <p:nvPr/>
        </p:nvSpPr>
        <p:spPr>
          <a:xfrm>
            <a:off x="586872" y="8711942"/>
            <a:ext cx="5684256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t-EE" sz="11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</a:t>
            </a:r>
            <a:r>
              <a:rPr lang="et-EE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9. 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ative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crographs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f Control and DC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amples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ained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ith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API,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imentin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VIM), </a:t>
            </a:r>
            <a:r>
              <a:rPr lang="el-GR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β-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atenin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and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mooth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uscle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ctin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SMA) are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own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cale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ar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s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200 µm.</a:t>
            </a:r>
            <a:r>
              <a:rPr lang="et-EE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en-GB" sz="11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ADB4BD5-7742-4D8C-80B8-BD936ACE07FF}"/>
              </a:ext>
            </a:extLst>
          </p:cNvPr>
          <p:cNvSpPr txBox="1"/>
          <p:nvPr/>
        </p:nvSpPr>
        <p:spPr>
          <a:xfrm>
            <a:off x="2271442" y="632324"/>
            <a:ext cx="7251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400" dirty="0"/>
              <a:t>Control</a:t>
            </a:r>
            <a:endParaRPr lang="en-GB" sz="14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0E0D898-5E5F-4C59-8A96-FC2353D5F628}"/>
              </a:ext>
            </a:extLst>
          </p:cNvPr>
          <p:cNvSpPr txBox="1"/>
          <p:nvPr/>
        </p:nvSpPr>
        <p:spPr>
          <a:xfrm>
            <a:off x="4249973" y="585463"/>
            <a:ext cx="3914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400" dirty="0"/>
              <a:t>DC</a:t>
            </a:r>
            <a:endParaRPr lang="en-GB" sz="14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0056BD4-C5FE-4EA2-A091-3D7DDCB281E2}"/>
              </a:ext>
            </a:extLst>
          </p:cNvPr>
          <p:cNvSpPr txBox="1"/>
          <p:nvPr/>
        </p:nvSpPr>
        <p:spPr>
          <a:xfrm>
            <a:off x="1143071" y="1449284"/>
            <a:ext cx="485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200" dirty="0"/>
              <a:t>DAPI</a:t>
            </a:r>
            <a:endParaRPr lang="en-GB" sz="12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D3BA756-2E20-471B-9CB3-5AF02FDBF6A8}"/>
              </a:ext>
            </a:extLst>
          </p:cNvPr>
          <p:cNvSpPr txBox="1"/>
          <p:nvPr/>
        </p:nvSpPr>
        <p:spPr>
          <a:xfrm>
            <a:off x="1290048" y="6927479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200" dirty="0"/>
              <a:t>M</a:t>
            </a:r>
            <a:endParaRPr lang="en-GB" sz="12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DE77A8F-8762-4804-967C-3994CE0CB71F}"/>
              </a:ext>
            </a:extLst>
          </p:cNvPr>
          <p:cNvSpPr txBox="1"/>
          <p:nvPr/>
        </p:nvSpPr>
        <p:spPr>
          <a:xfrm>
            <a:off x="1179482" y="5554414"/>
            <a:ext cx="11644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t-EE" sz="1200" dirty="0"/>
              <a:t>SMA</a:t>
            </a:r>
            <a:endParaRPr lang="en-GB" sz="12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957C284-D080-4A8A-A7A9-8B6C32773D3C}"/>
              </a:ext>
            </a:extLst>
          </p:cNvPr>
          <p:cNvSpPr txBox="1"/>
          <p:nvPr/>
        </p:nvSpPr>
        <p:spPr>
          <a:xfrm>
            <a:off x="954640" y="4046950"/>
            <a:ext cx="807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/>
              <a:t>β-</a:t>
            </a:r>
            <a:r>
              <a:rPr lang="et-EE" sz="1200" dirty="0" err="1"/>
              <a:t>catenin</a:t>
            </a:r>
            <a:r>
              <a:rPr lang="et-EE" sz="1200" dirty="0"/>
              <a:t> </a:t>
            </a:r>
            <a:endParaRPr lang="en-GB" sz="12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FF92CB4-E20F-4CA1-8159-423B8B594BF9}"/>
              </a:ext>
            </a:extLst>
          </p:cNvPr>
          <p:cNvSpPr txBox="1"/>
          <p:nvPr/>
        </p:nvSpPr>
        <p:spPr>
          <a:xfrm>
            <a:off x="1151909" y="2835948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200" dirty="0"/>
              <a:t>VIM</a:t>
            </a:r>
            <a:endParaRPr lang="en-GB" sz="1200" dirty="0"/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2DDBA717-0B7A-41E3-B8EA-5CAB1186F60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710385" y="893240"/>
            <a:ext cx="1847248" cy="1402202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FDD75F23-5B32-44FD-8A5E-9C2AB26BBDF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713433" y="2329095"/>
            <a:ext cx="1841152" cy="1402202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A7E436E2-DD79-4B47-8ACA-CBD84AB8B34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710385" y="3758432"/>
            <a:ext cx="1847248" cy="1408298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5E768734-6907-4C47-98E6-EA55EE2603E8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707337" y="5194216"/>
            <a:ext cx="1847248" cy="1402202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7EEB2C81-AF8D-41D6-8ED2-156CE6C4F568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707337" y="6638270"/>
            <a:ext cx="1847248" cy="1402202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777D98D7-A596-4045-818F-C0E8FCC13EED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639558" y="893240"/>
            <a:ext cx="1847248" cy="1402202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075A7BB0-88A7-47D9-BAA9-E16CBD067C57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639558" y="2314978"/>
            <a:ext cx="1847248" cy="1408298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62131033-2291-41D1-8129-D470511A254E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635741" y="3753068"/>
            <a:ext cx="1841152" cy="1402202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C318184F-1DA1-4CC2-B273-1E3516558FF1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635741" y="5189765"/>
            <a:ext cx="1841152" cy="1408298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484D7E72-1557-48A5-8BA4-2435C61A5AAA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635741" y="6639630"/>
            <a:ext cx="1841152" cy="14022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075851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ctangle 13">
            <a:extLst>
              <a:ext uri="{FF2B5EF4-FFF2-40B4-BE49-F238E27FC236}">
                <a16:creationId xmlns:a16="http://schemas.microsoft.com/office/drawing/2014/main" id="{14E0A028-CA21-4ED5-9EE4-CAEDA3C6FD43}"/>
              </a:ext>
            </a:extLst>
          </p:cNvPr>
          <p:cNvSpPr/>
          <p:nvPr/>
        </p:nvSpPr>
        <p:spPr>
          <a:xfrm>
            <a:off x="586872" y="8711942"/>
            <a:ext cx="5684256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t-EE" sz="11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</a:t>
            </a:r>
            <a:r>
              <a:rPr lang="et-EE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10. 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ative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crographs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f Control and DC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amples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ained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ith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API,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imentin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VIM), </a:t>
            </a:r>
            <a:r>
              <a:rPr lang="el-GR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β-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atenin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and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mooth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uscle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ctin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SMA) are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own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cale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ar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s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50 µm.</a:t>
            </a:r>
            <a:r>
              <a:rPr lang="et-EE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en-GB" sz="11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8A8BFC9-23C6-4A26-BA03-3B5A769A5A38}"/>
              </a:ext>
            </a:extLst>
          </p:cNvPr>
          <p:cNvSpPr txBox="1"/>
          <p:nvPr/>
        </p:nvSpPr>
        <p:spPr>
          <a:xfrm>
            <a:off x="2271442" y="632324"/>
            <a:ext cx="7251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400" dirty="0"/>
              <a:t>Control</a:t>
            </a:r>
            <a:endParaRPr lang="en-GB" sz="14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DA1074D-47F7-40B6-A9F6-C64C35D7D622}"/>
              </a:ext>
            </a:extLst>
          </p:cNvPr>
          <p:cNvSpPr txBox="1"/>
          <p:nvPr/>
        </p:nvSpPr>
        <p:spPr>
          <a:xfrm>
            <a:off x="4249973" y="585463"/>
            <a:ext cx="3914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400" dirty="0"/>
              <a:t>DC</a:t>
            </a:r>
            <a:endParaRPr lang="en-GB" sz="14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D415713-C6BC-432B-9D2A-67A8337624E7}"/>
              </a:ext>
            </a:extLst>
          </p:cNvPr>
          <p:cNvSpPr txBox="1"/>
          <p:nvPr/>
        </p:nvSpPr>
        <p:spPr>
          <a:xfrm>
            <a:off x="1143071" y="1449284"/>
            <a:ext cx="485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200" dirty="0"/>
              <a:t>DAPI</a:t>
            </a:r>
            <a:endParaRPr lang="en-GB" sz="12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534A158-1230-422F-8605-EC5944AC12F0}"/>
              </a:ext>
            </a:extLst>
          </p:cNvPr>
          <p:cNvSpPr txBox="1"/>
          <p:nvPr/>
        </p:nvSpPr>
        <p:spPr>
          <a:xfrm>
            <a:off x="1290048" y="6927479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200" dirty="0"/>
              <a:t>M</a:t>
            </a:r>
            <a:endParaRPr lang="en-GB" sz="12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A84798F-A6CD-4588-9435-AE271BEB9D99}"/>
              </a:ext>
            </a:extLst>
          </p:cNvPr>
          <p:cNvSpPr txBox="1"/>
          <p:nvPr/>
        </p:nvSpPr>
        <p:spPr>
          <a:xfrm>
            <a:off x="1179482" y="5554414"/>
            <a:ext cx="11644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t-EE" sz="1200" dirty="0"/>
              <a:t>SMA</a:t>
            </a:r>
            <a:endParaRPr lang="en-GB" sz="12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46317F8-3CA4-4F14-B660-904A78ABD66E}"/>
              </a:ext>
            </a:extLst>
          </p:cNvPr>
          <p:cNvSpPr txBox="1"/>
          <p:nvPr/>
        </p:nvSpPr>
        <p:spPr>
          <a:xfrm>
            <a:off x="954640" y="4046950"/>
            <a:ext cx="807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/>
              <a:t>β-</a:t>
            </a:r>
            <a:r>
              <a:rPr lang="et-EE" sz="1200" dirty="0" err="1"/>
              <a:t>catenin</a:t>
            </a:r>
            <a:r>
              <a:rPr lang="et-EE" sz="1200" dirty="0"/>
              <a:t> </a:t>
            </a:r>
            <a:endParaRPr lang="en-GB" sz="12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3D0E4C0-12D9-4908-A6BC-FF69672819D7}"/>
              </a:ext>
            </a:extLst>
          </p:cNvPr>
          <p:cNvSpPr txBox="1"/>
          <p:nvPr/>
        </p:nvSpPr>
        <p:spPr>
          <a:xfrm>
            <a:off x="1151909" y="2835948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200" dirty="0"/>
              <a:t>VIM</a:t>
            </a:r>
            <a:endParaRPr lang="en-GB" sz="1200" dirty="0"/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40D01F1E-CAC2-4C70-BA20-282D2D06D69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713433" y="901961"/>
            <a:ext cx="1841152" cy="1402202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09C7F0F3-2DCD-4138-AA20-35492E83332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713433" y="2331925"/>
            <a:ext cx="1841152" cy="1408298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6622B408-B2BE-4BBD-BB68-BD3835E9D45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706466" y="3767985"/>
            <a:ext cx="1841152" cy="1402202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D133C293-1966-4316-B8EE-B2E593A757E3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706466" y="5212454"/>
            <a:ext cx="1841152" cy="1408298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BF5A478F-67FC-4C6C-8F9E-3FBE91FC8DFA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713433" y="6660034"/>
            <a:ext cx="1841152" cy="1408298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A9235D93-75D9-4A3E-BD0B-0D463E09C0CC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602872" y="887393"/>
            <a:ext cx="1841152" cy="1402202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5BB80BE1-4C97-4E04-B479-45A784263ADD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602126" y="2331862"/>
            <a:ext cx="1841152" cy="1408298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E42924F7-5979-41F0-867D-170AAA261DCF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602126" y="3782427"/>
            <a:ext cx="1841152" cy="1402202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5A30348B-0153-4709-A46D-880EBD9C7DA6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602126" y="5212454"/>
            <a:ext cx="1841152" cy="1402202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9E629B45-DD11-46A0-A097-38EA16050C56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607716" y="6656860"/>
            <a:ext cx="1841152" cy="14082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52620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2221405E-B4EE-4ED5-83D3-F0BC58D21F5F}"/>
              </a:ext>
            </a:extLst>
          </p:cNvPr>
          <p:cNvSpPr/>
          <p:nvPr/>
        </p:nvSpPr>
        <p:spPr>
          <a:xfrm>
            <a:off x="1419830" y="953675"/>
            <a:ext cx="4018340" cy="4099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 </a:t>
            </a:r>
            <a:r>
              <a:rPr lang="et-EE" sz="12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.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escription of samples used in the current study.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D9BAD5D-06F8-4B03-908F-70167BA7B1E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98832560"/>
              </p:ext>
            </p:extLst>
          </p:nvPr>
        </p:nvGraphicFramePr>
        <p:xfrm>
          <a:off x="1081690" y="1487273"/>
          <a:ext cx="4694619" cy="7221561"/>
        </p:xfrm>
        <a:graphic>
          <a:graphicData uri="http://schemas.openxmlformats.org/drawingml/2006/table">
            <a:tbl>
              <a:tblPr firstRow="1" firstCol="1" bandRow="1"/>
              <a:tblGrid>
                <a:gridCol w="910984">
                  <a:extLst>
                    <a:ext uri="{9D8B030D-6E8A-4147-A177-3AD203B41FA5}">
                      <a16:colId xmlns:a16="http://schemas.microsoft.com/office/drawing/2014/main" val="3256194030"/>
                    </a:ext>
                  </a:extLst>
                </a:gridCol>
                <a:gridCol w="521369">
                  <a:extLst>
                    <a:ext uri="{9D8B030D-6E8A-4147-A177-3AD203B41FA5}">
                      <a16:colId xmlns:a16="http://schemas.microsoft.com/office/drawing/2014/main" val="1024022973"/>
                    </a:ext>
                  </a:extLst>
                </a:gridCol>
                <a:gridCol w="597457">
                  <a:extLst>
                    <a:ext uri="{9D8B030D-6E8A-4147-A177-3AD203B41FA5}">
                      <a16:colId xmlns:a16="http://schemas.microsoft.com/office/drawing/2014/main" val="906454875"/>
                    </a:ext>
                  </a:extLst>
                </a:gridCol>
                <a:gridCol w="1287490">
                  <a:extLst>
                    <a:ext uri="{9D8B030D-6E8A-4147-A177-3AD203B41FA5}">
                      <a16:colId xmlns:a16="http://schemas.microsoft.com/office/drawing/2014/main" val="4028182556"/>
                    </a:ext>
                  </a:extLst>
                </a:gridCol>
                <a:gridCol w="1377319">
                  <a:extLst>
                    <a:ext uri="{9D8B030D-6E8A-4147-A177-3AD203B41FA5}">
                      <a16:colId xmlns:a16="http://schemas.microsoft.com/office/drawing/2014/main" val="944678935"/>
                    </a:ext>
                  </a:extLst>
                </a:gridCol>
              </a:tblGrid>
              <a:tr h="208391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ample name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ge</a:t>
                      </a:r>
                      <a:r>
                        <a:rPr lang="et-EE" sz="105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(y)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ex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xperiment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ndition</a:t>
                      </a:r>
                      <a:r>
                        <a:rPr lang="et-EE" sz="105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                                 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2050104"/>
                  </a:ext>
                </a:extLst>
              </a:tr>
              <a:tr h="33072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ntrol1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4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an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oteomics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ntrol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9479416"/>
                  </a:ext>
                </a:extLst>
              </a:tr>
              <a:tr h="33072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ntrol2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8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oman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oteomics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ntrol 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2058632"/>
                  </a:ext>
                </a:extLst>
              </a:tr>
              <a:tr h="33072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ntrol3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2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oman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oteomics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ntrol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9278768"/>
                  </a:ext>
                </a:extLst>
              </a:tr>
              <a:tr h="33072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ntrol4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0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oman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oteomics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ntrol 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3651506"/>
                  </a:ext>
                </a:extLst>
              </a:tr>
              <a:tr h="33072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ntrol5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2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an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oteomics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ntrol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4531605"/>
                  </a:ext>
                </a:extLst>
              </a:tr>
              <a:tr h="33072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ntrol6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4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oman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oteomics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ntrol 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1019754"/>
                  </a:ext>
                </a:extLst>
              </a:tr>
              <a:tr h="33072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ntrol7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0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an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oteomics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ntrol 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27936777"/>
                  </a:ext>
                </a:extLst>
              </a:tr>
              <a:tr h="33072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ntrol8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2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Woman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oteomics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ntrol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3411441"/>
                  </a:ext>
                </a:extLst>
              </a:tr>
              <a:tr h="33072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ntrol9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3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Woman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oteomics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ntrol 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2040906"/>
                  </a:ext>
                </a:extLst>
              </a:tr>
              <a:tr h="33072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ntrol10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1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oman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mmunofluorescence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ntrol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2044800"/>
                  </a:ext>
                </a:extLst>
              </a:tr>
              <a:tr h="33072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ntrol</a:t>
                      </a: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4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oman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mmunofluorescence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ntrol 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73461741"/>
                  </a:ext>
                </a:extLst>
              </a:tr>
              <a:tr h="33072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ntrol12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3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oman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mmunofluorescence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ntrol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5046686"/>
                  </a:ext>
                </a:extLst>
              </a:tr>
              <a:tr h="33072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</a:t>
                      </a: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</a:t>
                      </a: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7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an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oteomics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C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1424539"/>
                  </a:ext>
                </a:extLst>
              </a:tr>
              <a:tr h="33072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</a:t>
                      </a: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</a:t>
                      </a: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2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an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oteomics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C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8617655"/>
                  </a:ext>
                </a:extLst>
              </a:tr>
              <a:tr h="331336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</a:t>
                      </a: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</a:t>
                      </a: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8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oman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oteomics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C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2288351"/>
                  </a:ext>
                </a:extLst>
              </a:tr>
              <a:tr h="33072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</a:t>
                      </a: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</a:t>
                      </a: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0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an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oteomics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C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2253595"/>
                  </a:ext>
                </a:extLst>
              </a:tr>
              <a:tr h="33072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</a:t>
                      </a: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</a:t>
                      </a: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5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an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oteomics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C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7495956"/>
                  </a:ext>
                </a:extLst>
              </a:tr>
              <a:tr h="33072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</a:t>
                      </a: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</a:t>
                      </a: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6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an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oteomics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C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4857736"/>
                  </a:ext>
                </a:extLst>
              </a:tr>
              <a:tr h="33072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</a:t>
                      </a: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</a:t>
                      </a: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4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an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oteomics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C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395448"/>
                  </a:ext>
                </a:extLst>
              </a:tr>
              <a:tr h="33072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</a:t>
                      </a: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</a:t>
                      </a: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2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an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oteomics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C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90195339"/>
                  </a:ext>
                </a:extLst>
              </a:tr>
              <a:tr h="331336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</a:t>
                      </a: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</a:t>
                      </a: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9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3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om</a:t>
                      </a: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n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oteomics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C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0305791"/>
                  </a:ext>
                </a:extLst>
              </a:tr>
            </a:tbl>
          </a:graphicData>
        </a:graphic>
      </p:graphicFrame>
      <p:sp>
        <p:nvSpPr>
          <p:cNvPr id="13" name="Rectángulo 63">
            <a:extLst>
              <a:ext uri="{FF2B5EF4-FFF2-40B4-BE49-F238E27FC236}">
                <a16:creationId xmlns:a16="http://schemas.microsoft.com/office/drawing/2014/main" id="{31D5FA07-A840-4413-8622-48A9A3759FA1}"/>
              </a:ext>
            </a:extLst>
          </p:cNvPr>
          <p:cNvSpPr/>
          <p:nvPr/>
        </p:nvSpPr>
        <p:spPr>
          <a:xfrm>
            <a:off x="2828304" y="728222"/>
            <a:ext cx="1560042" cy="24820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MX" sz="1013" u="sng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MX" sz="1013" u="sng" dirty="0">
                <a:latin typeface="Arial" panose="020B0604020202020204" pitchFamily="34" charset="0"/>
                <a:cs typeface="Arial" panose="020B0604020202020204" pitchFamily="34" charset="0"/>
              </a:rPr>
              <a:t> material</a:t>
            </a:r>
            <a:endParaRPr lang="es-ES" sz="1013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91569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E243BF7C-179C-4AFA-99F6-80F131FD11B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82361326"/>
              </p:ext>
            </p:extLst>
          </p:nvPr>
        </p:nvGraphicFramePr>
        <p:xfrm>
          <a:off x="1194820" y="1384973"/>
          <a:ext cx="4694619" cy="2319352"/>
        </p:xfrm>
        <a:graphic>
          <a:graphicData uri="http://schemas.openxmlformats.org/drawingml/2006/table">
            <a:tbl>
              <a:tblPr firstRow="1" firstCol="1" bandRow="1"/>
              <a:tblGrid>
                <a:gridCol w="910984">
                  <a:extLst>
                    <a:ext uri="{9D8B030D-6E8A-4147-A177-3AD203B41FA5}">
                      <a16:colId xmlns:a16="http://schemas.microsoft.com/office/drawing/2014/main" val="458927634"/>
                    </a:ext>
                  </a:extLst>
                </a:gridCol>
                <a:gridCol w="521369">
                  <a:extLst>
                    <a:ext uri="{9D8B030D-6E8A-4147-A177-3AD203B41FA5}">
                      <a16:colId xmlns:a16="http://schemas.microsoft.com/office/drawing/2014/main" val="2029280288"/>
                    </a:ext>
                  </a:extLst>
                </a:gridCol>
                <a:gridCol w="597457">
                  <a:extLst>
                    <a:ext uri="{9D8B030D-6E8A-4147-A177-3AD203B41FA5}">
                      <a16:colId xmlns:a16="http://schemas.microsoft.com/office/drawing/2014/main" val="431854990"/>
                    </a:ext>
                  </a:extLst>
                </a:gridCol>
                <a:gridCol w="1287490">
                  <a:extLst>
                    <a:ext uri="{9D8B030D-6E8A-4147-A177-3AD203B41FA5}">
                      <a16:colId xmlns:a16="http://schemas.microsoft.com/office/drawing/2014/main" val="3451850834"/>
                    </a:ext>
                  </a:extLst>
                </a:gridCol>
                <a:gridCol w="1377319">
                  <a:extLst>
                    <a:ext uri="{9D8B030D-6E8A-4147-A177-3AD203B41FA5}">
                      <a16:colId xmlns:a16="http://schemas.microsoft.com/office/drawing/2014/main" val="3552513785"/>
                    </a:ext>
                  </a:extLst>
                </a:gridCol>
              </a:tblGrid>
              <a:tr h="331336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ample name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ge</a:t>
                      </a:r>
                      <a:r>
                        <a:rPr lang="et-EE" sz="105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(y)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ex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xperiment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ndition</a:t>
                      </a:r>
                      <a:r>
                        <a:rPr lang="et-EE" sz="105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                                 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6406993"/>
                  </a:ext>
                </a:extLst>
              </a:tr>
              <a:tr h="331336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</a:t>
                      </a: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10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9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an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mmunofluorescence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C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3568376"/>
                  </a:ext>
                </a:extLst>
              </a:tr>
              <a:tr h="331336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</a:t>
                      </a: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11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1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an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mmunofluorescence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C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86682386"/>
                  </a:ext>
                </a:extLst>
              </a:tr>
              <a:tr h="331336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</a:t>
                      </a: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12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3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an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mmunofluorescence</a:t>
                      </a:r>
                      <a:endParaRPr lang="en-GB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C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6177980"/>
                  </a:ext>
                </a:extLst>
              </a:tr>
              <a:tr h="331336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C13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3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an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mmunofluorescence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C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2410769"/>
                  </a:ext>
                </a:extLst>
              </a:tr>
              <a:tr h="331336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C14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1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Woman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mmunofluorescence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C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7226089"/>
                  </a:ext>
                </a:extLst>
              </a:tr>
              <a:tr h="331336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C15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2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an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mmunofluorescence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t-EE" sz="105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C</a:t>
                      </a:r>
                      <a:endParaRPr lang="en-GB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514" marR="6651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0329520"/>
                  </a:ext>
                </a:extLst>
              </a:tr>
            </a:tbl>
          </a:graphicData>
        </a:graphic>
      </p:graphicFrame>
      <p:sp>
        <p:nvSpPr>
          <p:cNvPr id="5" name="Rectangle 4">
            <a:extLst>
              <a:ext uri="{FF2B5EF4-FFF2-40B4-BE49-F238E27FC236}">
                <a16:creationId xmlns:a16="http://schemas.microsoft.com/office/drawing/2014/main" id="{22D98EA5-59D8-405C-8799-72E818149E8C}"/>
              </a:ext>
            </a:extLst>
          </p:cNvPr>
          <p:cNvSpPr/>
          <p:nvPr/>
        </p:nvSpPr>
        <p:spPr>
          <a:xfrm>
            <a:off x="1132512" y="926379"/>
            <a:ext cx="4694619" cy="4099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 </a:t>
            </a:r>
            <a:r>
              <a:rPr lang="et-EE" sz="12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t-EE" sz="12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ntinuation</a:t>
            </a:r>
            <a:r>
              <a:rPr lang="et-EE" sz="12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escription of samples used in the current study.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8319C8D2-01AB-4829-BFE8-5E4D706F58A3}"/>
              </a:ext>
            </a:extLst>
          </p:cNvPr>
          <p:cNvSpPr/>
          <p:nvPr/>
        </p:nvSpPr>
        <p:spPr>
          <a:xfrm>
            <a:off x="676054" y="3752935"/>
            <a:ext cx="584133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800"/>
              </a:spcAft>
            </a:pP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amples description show name</a:t>
            </a:r>
            <a:r>
              <a:rPr lang="et-EE" sz="12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condition which were derived: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upuytren’s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nodular tissue samples (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upuytren’s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200" dirty="0" err="1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ntracture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D</a:t>
            </a:r>
            <a:r>
              <a:rPr lang="et-EE" sz="12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and palmar fascia tissue (Control samples). Age</a:t>
            </a:r>
            <a:r>
              <a:rPr lang="et-EE" sz="12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lang="et-EE" sz="1200" dirty="0" err="1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year</a:t>
            </a:r>
            <a:r>
              <a:rPr lang="et-EE" sz="12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y)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and sex is presented, as well as experiment for which were used. </a:t>
            </a:r>
          </a:p>
        </p:txBody>
      </p:sp>
    </p:spTree>
    <p:extLst>
      <p:ext uri="{BB962C8B-B14F-4D97-AF65-F5344CB8AC3E}">
        <p14:creationId xmlns:p14="http://schemas.microsoft.com/office/powerpoint/2010/main" val="24895484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38644544-17C2-4B6A-A427-C540580F513C}"/>
              </a:ext>
            </a:extLst>
          </p:cNvPr>
          <p:cNvSpPr/>
          <p:nvPr/>
        </p:nvSpPr>
        <p:spPr>
          <a:xfrm>
            <a:off x="1482926" y="937313"/>
            <a:ext cx="3892147" cy="4099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GB" sz="1200" b="1" dirty="0">
                <a:solidFill>
                  <a:srgbClr val="1C1D1E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Table S</a:t>
            </a:r>
            <a:r>
              <a:rPr lang="en-US" sz="1200" b="1" dirty="0">
                <a:solidFill>
                  <a:srgbClr val="1C1D1E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3</a:t>
            </a:r>
            <a:r>
              <a:rPr lang="en-GB" sz="1200" b="1" dirty="0">
                <a:solidFill>
                  <a:srgbClr val="1C1D1E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r>
              <a:rPr lang="en-GB" sz="1200" dirty="0">
                <a:solidFill>
                  <a:srgbClr val="1C1D1E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Antibodies used in immunofluorescence analysis.</a:t>
            </a:r>
            <a:endParaRPr lang="en-GB" sz="1200" dirty="0"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E81320B5-4D86-44F2-8873-A791F7062F4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8834769"/>
              </p:ext>
            </p:extLst>
          </p:nvPr>
        </p:nvGraphicFramePr>
        <p:xfrm>
          <a:off x="941752" y="1499697"/>
          <a:ext cx="4974495" cy="3157232"/>
        </p:xfrm>
        <a:graphic>
          <a:graphicData uri="http://schemas.openxmlformats.org/drawingml/2006/table">
            <a:tbl>
              <a:tblPr bandRow="1"/>
              <a:tblGrid>
                <a:gridCol w="1975480">
                  <a:extLst>
                    <a:ext uri="{9D8B030D-6E8A-4147-A177-3AD203B41FA5}">
                      <a16:colId xmlns:a16="http://schemas.microsoft.com/office/drawing/2014/main" val="161783633"/>
                    </a:ext>
                  </a:extLst>
                </a:gridCol>
                <a:gridCol w="1369018">
                  <a:extLst>
                    <a:ext uri="{9D8B030D-6E8A-4147-A177-3AD203B41FA5}">
                      <a16:colId xmlns:a16="http://schemas.microsoft.com/office/drawing/2014/main" val="2990341276"/>
                    </a:ext>
                  </a:extLst>
                </a:gridCol>
                <a:gridCol w="590411">
                  <a:extLst>
                    <a:ext uri="{9D8B030D-6E8A-4147-A177-3AD203B41FA5}">
                      <a16:colId xmlns:a16="http://schemas.microsoft.com/office/drawing/2014/main" val="389542338"/>
                    </a:ext>
                  </a:extLst>
                </a:gridCol>
                <a:gridCol w="1039586">
                  <a:extLst>
                    <a:ext uri="{9D8B030D-6E8A-4147-A177-3AD203B41FA5}">
                      <a16:colId xmlns:a16="http://schemas.microsoft.com/office/drawing/2014/main" val="676535639"/>
                    </a:ext>
                  </a:extLst>
                </a:gridCol>
              </a:tblGrid>
              <a:tr h="273824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dirty="0">
                          <a:solidFill>
                            <a:srgbClr val="1C1D1E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Antibody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t-EE" sz="1000" b="1" dirty="0">
                          <a:solidFill>
                            <a:srgbClr val="1C1D1E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C</a:t>
                      </a:r>
                      <a:r>
                        <a:rPr lang="en-GB" sz="1000" b="1" dirty="0">
                          <a:solidFill>
                            <a:srgbClr val="1C1D1E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at no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dirty="0">
                          <a:solidFill>
                            <a:srgbClr val="1C1D1E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Dilution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dirty="0">
                          <a:solidFill>
                            <a:srgbClr val="1C1D1E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Source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433215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1C1D1E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Alexa Flour 488 Donkey anti-</a:t>
                      </a:r>
                      <a:r>
                        <a:rPr lang="et-EE" sz="1000" dirty="0" err="1">
                          <a:solidFill>
                            <a:srgbClr val="1C1D1E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Goat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1C1D1E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A</a:t>
                      </a:r>
                      <a:r>
                        <a:rPr lang="et-EE" sz="1000" dirty="0">
                          <a:solidFill>
                            <a:srgbClr val="1C1D1E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11055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t-EE" sz="1000" dirty="0">
                          <a:solidFill>
                            <a:srgbClr val="1C1D1E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IF: </a:t>
                      </a:r>
                      <a:r>
                        <a:rPr lang="en-GB" sz="1000" dirty="0">
                          <a:solidFill>
                            <a:srgbClr val="1C1D1E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1:</a:t>
                      </a:r>
                      <a:r>
                        <a:rPr lang="et-EE" sz="1000" dirty="0">
                          <a:solidFill>
                            <a:srgbClr val="1C1D1E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200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solidFill>
                            <a:srgbClr val="1C1D1E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Thermo Fisher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260380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1C1D1E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Alexa Flour </a:t>
                      </a:r>
                      <a:r>
                        <a:rPr lang="et-EE" sz="1000" dirty="0">
                          <a:solidFill>
                            <a:srgbClr val="1C1D1E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594</a:t>
                      </a:r>
                      <a:r>
                        <a:rPr lang="en-GB" sz="1000" dirty="0">
                          <a:solidFill>
                            <a:srgbClr val="1C1D1E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 Donkey anti-Rabbit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t-EE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A21207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t-EE" sz="1000" dirty="0">
                          <a:solidFill>
                            <a:srgbClr val="1C1D1E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IF: </a:t>
                      </a:r>
                      <a:r>
                        <a:rPr lang="en-GB" sz="1000" dirty="0">
                          <a:solidFill>
                            <a:srgbClr val="1C1D1E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1:</a:t>
                      </a:r>
                      <a:r>
                        <a:rPr lang="et-EE" sz="1000" dirty="0">
                          <a:solidFill>
                            <a:srgbClr val="1C1D1E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200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1C1D1E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Thermo Fisher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764044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1C1D1E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Alexa Flour 647 Donkey anti-Mouse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1C1D1E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A31571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t-EE" sz="1000" dirty="0">
                          <a:solidFill>
                            <a:srgbClr val="1C1D1E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IF: </a:t>
                      </a:r>
                      <a:r>
                        <a:rPr lang="en-GB" sz="1000" dirty="0">
                          <a:solidFill>
                            <a:srgbClr val="1C1D1E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1:</a:t>
                      </a:r>
                      <a:r>
                        <a:rPr lang="et-EE" sz="1000" dirty="0">
                          <a:solidFill>
                            <a:srgbClr val="1C1D1E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200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1C1D1E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Thermo Fisher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483146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t-EE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CTGF anti-</a:t>
                      </a:r>
                      <a:r>
                        <a:rPr lang="et-EE" sz="10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goat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t-EE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Sc-14939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t-EE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1:50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t-EE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Santa </a:t>
                      </a:r>
                      <a:r>
                        <a:rPr lang="et-EE" sz="10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cruz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623458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t-EE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K15 anti-</a:t>
                      </a:r>
                      <a:r>
                        <a:rPr lang="et-EE" sz="10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mouse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t-EE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ab800522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t-EE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1:50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t-EE" sz="10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Abcam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502295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t-EE" sz="10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Collagen</a:t>
                      </a:r>
                      <a:r>
                        <a:rPr lang="et-EE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-IV anti-</a:t>
                      </a:r>
                      <a:r>
                        <a:rPr lang="et-EE" sz="10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rabbit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t-EE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ab6586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t-EE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1:100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t-EE" sz="10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Abcam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388107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t-EE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E-</a:t>
                      </a:r>
                      <a:r>
                        <a:rPr lang="et-EE" sz="10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cadherin</a:t>
                      </a:r>
                      <a:r>
                        <a:rPr lang="et-EE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 anti-</a:t>
                      </a:r>
                      <a:r>
                        <a:rPr lang="et-EE" sz="10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mouse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t-EE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MA5-12547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t-EE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1:100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t-EE" sz="10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Invitrogen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702542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t-EE" sz="10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Decorin</a:t>
                      </a:r>
                      <a:r>
                        <a:rPr lang="et-EE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 anti-</a:t>
                      </a:r>
                      <a:r>
                        <a:rPr lang="et-EE" sz="10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rabbit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t-EE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Sc-22753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t-EE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1:100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t-EE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Santa </a:t>
                      </a:r>
                      <a:r>
                        <a:rPr lang="et-EE" sz="10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cruz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0810174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l-GR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β</a:t>
                      </a:r>
                      <a:r>
                        <a:rPr lang="et-EE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-</a:t>
                      </a:r>
                      <a:r>
                        <a:rPr lang="et-EE" sz="10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catenin</a:t>
                      </a:r>
                      <a:r>
                        <a:rPr lang="et-EE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 anti-</a:t>
                      </a:r>
                      <a:r>
                        <a:rPr lang="et-EE" sz="10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rabbit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t-EE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9581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t-EE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1:100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t-EE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Cell </a:t>
                      </a:r>
                      <a:r>
                        <a:rPr lang="et-EE" sz="10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signaling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892078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t-EE" sz="10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Vimentin</a:t>
                      </a:r>
                      <a:r>
                        <a:rPr lang="et-EE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 anti-</a:t>
                      </a:r>
                      <a:r>
                        <a:rPr lang="et-EE" sz="10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goat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t-EE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AF2105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t-EE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1:100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t-EE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R&amp;D </a:t>
                      </a:r>
                      <a:r>
                        <a:rPr lang="et-EE" sz="10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systems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180348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t-EE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SMA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clone </a:t>
                      </a:r>
                      <a:r>
                        <a:rPr lang="el-GR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α</a:t>
                      </a: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sm-1, NCL-SMA</a:t>
                      </a: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t-EE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1:50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t-EE" sz="10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Leica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59695" marR="5969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5230892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98262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A6247812-24C1-4253-811C-F7E0515FE3A6}"/>
              </a:ext>
            </a:extLst>
          </p:cNvPr>
          <p:cNvGrpSpPr/>
          <p:nvPr/>
        </p:nvGrpSpPr>
        <p:grpSpPr>
          <a:xfrm>
            <a:off x="1997862" y="639503"/>
            <a:ext cx="2842444" cy="2131833"/>
            <a:chOff x="582901" y="625435"/>
            <a:chExt cx="2842444" cy="2131833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4119D491-57CE-4A14-AFE7-22EFD0B0B42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2901" y="625435"/>
              <a:ext cx="2842444" cy="2131833"/>
            </a:xfrm>
            <a:prstGeom prst="rect">
              <a:avLst/>
            </a:prstGeom>
          </p:spPr>
        </p:pic>
        <p:sp>
          <p:nvSpPr>
            <p:cNvPr id="5" name="Arrow: Down 4">
              <a:extLst>
                <a:ext uri="{FF2B5EF4-FFF2-40B4-BE49-F238E27FC236}">
                  <a16:creationId xmlns:a16="http://schemas.microsoft.com/office/drawing/2014/main" id="{0673A93B-94A4-4B79-B3E3-065429CBE5D2}"/>
                </a:ext>
              </a:extLst>
            </p:cNvPr>
            <p:cNvSpPr/>
            <p:nvPr/>
          </p:nvSpPr>
          <p:spPr>
            <a:xfrm rot="3776018">
              <a:off x="1928385" y="1140627"/>
              <a:ext cx="455383" cy="478301"/>
            </a:xfrm>
            <a:prstGeom prst="downArrow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pic>
        <p:nvPicPr>
          <p:cNvPr id="7" name="Picture 6">
            <a:extLst>
              <a:ext uri="{FF2B5EF4-FFF2-40B4-BE49-F238E27FC236}">
                <a16:creationId xmlns:a16="http://schemas.microsoft.com/office/drawing/2014/main" id="{176A6F9F-E7C4-4636-9E63-EBEAC51DCAD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0923" y="3030051"/>
            <a:ext cx="5404344" cy="498591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E0BF5EC1-2632-4346-8BC6-E381F5B5A2DE}"/>
              </a:ext>
            </a:extLst>
          </p:cNvPr>
          <p:cNvSpPr txBox="1"/>
          <p:nvPr/>
        </p:nvSpPr>
        <p:spPr>
          <a:xfrm>
            <a:off x="1575581" y="598443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200" dirty="0"/>
              <a:t>A</a:t>
            </a:r>
            <a:endParaRPr lang="en-GB" sz="12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90A0648-CFA9-45E7-8713-CA42C3A0291C}"/>
              </a:ext>
            </a:extLst>
          </p:cNvPr>
          <p:cNvSpPr txBox="1"/>
          <p:nvPr/>
        </p:nvSpPr>
        <p:spPr>
          <a:xfrm>
            <a:off x="582901" y="3030051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200" dirty="0"/>
              <a:t>B</a:t>
            </a:r>
            <a:endParaRPr lang="en-GB" sz="1200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EA786999-4275-4CF8-8E72-DAEBF01E1FB9}"/>
              </a:ext>
            </a:extLst>
          </p:cNvPr>
          <p:cNvSpPr/>
          <p:nvPr/>
        </p:nvSpPr>
        <p:spPr>
          <a:xfrm>
            <a:off x="571011" y="8586679"/>
            <a:ext cx="5684256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t-EE" sz="11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</a:t>
            </a:r>
            <a:r>
              <a:rPr lang="et-EE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1. 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ative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crograph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f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 sweat gland before collection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A).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EGG mapper outcomes from the proteomic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alysis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“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herens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junction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”. R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d color shows the proteins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own-regulated, while green color shows the proteins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p-regulated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B).</a:t>
            </a:r>
            <a:endParaRPr lang="en-GB" sz="1100" dirty="0"/>
          </a:p>
        </p:txBody>
      </p:sp>
    </p:spTree>
    <p:extLst>
      <p:ext uri="{BB962C8B-B14F-4D97-AF65-F5344CB8AC3E}">
        <p14:creationId xmlns:p14="http://schemas.microsoft.com/office/powerpoint/2010/main" val="200648636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748925C-5B0B-4602-9F37-252A09FFFE6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8932" y="651946"/>
            <a:ext cx="4425009" cy="4218509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DA53AA56-A409-46B6-923E-0D65A7A1E490}"/>
              </a:ext>
            </a:extLst>
          </p:cNvPr>
          <p:cNvSpPr txBox="1"/>
          <p:nvPr/>
        </p:nvSpPr>
        <p:spPr>
          <a:xfrm>
            <a:off x="509217" y="651946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200" dirty="0"/>
              <a:t>A</a:t>
            </a:r>
            <a:endParaRPr lang="en-GB" sz="12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11016B7-7E09-4B1B-A226-33D32ED896D8}"/>
              </a:ext>
            </a:extLst>
          </p:cNvPr>
          <p:cNvSpPr txBox="1"/>
          <p:nvPr/>
        </p:nvSpPr>
        <p:spPr>
          <a:xfrm>
            <a:off x="522041" y="4980659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200" dirty="0"/>
              <a:t>B</a:t>
            </a:r>
            <a:endParaRPr lang="en-GB" sz="12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CAD8747-74E1-4BF9-85D9-6F718DD552F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8932" y="5047555"/>
            <a:ext cx="4425009" cy="3404390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50365E49-3BE2-4BCF-806B-F5E92037B8D1}"/>
              </a:ext>
            </a:extLst>
          </p:cNvPr>
          <p:cNvSpPr/>
          <p:nvPr/>
        </p:nvSpPr>
        <p:spPr>
          <a:xfrm>
            <a:off x="571011" y="8586679"/>
            <a:ext cx="5684256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t-EE" sz="11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</a:t>
            </a:r>
            <a:r>
              <a:rPr lang="et-EE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2.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EGG mapper outcomes from the proteomic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alysis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“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xtracellular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atrix-receptor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teraction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” (A), “PI3K-AKT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ignaling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thway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” (B). R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d color shows the proteins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own-regulated, while green color shows the proteins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p-regulated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en-GB" sz="1100" dirty="0"/>
          </a:p>
        </p:txBody>
      </p:sp>
    </p:spTree>
    <p:extLst>
      <p:ext uri="{BB962C8B-B14F-4D97-AF65-F5344CB8AC3E}">
        <p14:creationId xmlns:p14="http://schemas.microsoft.com/office/powerpoint/2010/main" val="69543791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>
            <a:extLst>
              <a:ext uri="{FF2B5EF4-FFF2-40B4-BE49-F238E27FC236}">
                <a16:creationId xmlns:a16="http://schemas.microsoft.com/office/drawing/2014/main" id="{86C86E0F-7FEB-4B4E-8354-8FD3E9A5D4A0}"/>
              </a:ext>
            </a:extLst>
          </p:cNvPr>
          <p:cNvSpPr txBox="1"/>
          <p:nvPr/>
        </p:nvSpPr>
        <p:spPr>
          <a:xfrm>
            <a:off x="2271443" y="632325"/>
            <a:ext cx="65564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t-EE" sz="1400" dirty="0"/>
              <a:t>Control</a:t>
            </a:r>
            <a:endParaRPr lang="en-GB" sz="14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7BAE280-0D76-4081-9E1D-106826B17946}"/>
              </a:ext>
            </a:extLst>
          </p:cNvPr>
          <p:cNvSpPr txBox="1"/>
          <p:nvPr/>
        </p:nvSpPr>
        <p:spPr>
          <a:xfrm>
            <a:off x="4915552" y="632324"/>
            <a:ext cx="7232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t-EE" sz="1400" dirty="0"/>
              <a:t>DC</a:t>
            </a:r>
            <a:endParaRPr lang="en-GB" sz="14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30F370F-4ABC-4E90-AB36-E7CE5A732C15}"/>
              </a:ext>
            </a:extLst>
          </p:cNvPr>
          <p:cNvSpPr txBox="1"/>
          <p:nvPr/>
        </p:nvSpPr>
        <p:spPr>
          <a:xfrm>
            <a:off x="897053" y="1563294"/>
            <a:ext cx="5346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400" dirty="0"/>
              <a:t>DAPI</a:t>
            </a:r>
            <a:endParaRPr lang="en-GB" sz="14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D0F2E93-8C96-47A5-94C4-04FA5E91E639}"/>
              </a:ext>
            </a:extLst>
          </p:cNvPr>
          <p:cNvSpPr txBox="1"/>
          <p:nvPr/>
        </p:nvSpPr>
        <p:spPr>
          <a:xfrm>
            <a:off x="692102" y="7727152"/>
            <a:ext cx="7562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400" dirty="0" err="1"/>
              <a:t>Merged</a:t>
            </a:r>
            <a:endParaRPr lang="en-GB" sz="14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43C71A6-22B0-499F-A04D-71B357203198}"/>
              </a:ext>
            </a:extLst>
          </p:cNvPr>
          <p:cNvSpPr txBox="1"/>
          <p:nvPr/>
        </p:nvSpPr>
        <p:spPr>
          <a:xfrm>
            <a:off x="852508" y="6274769"/>
            <a:ext cx="5389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t-EE" sz="1400" dirty="0"/>
              <a:t>K15</a:t>
            </a:r>
            <a:endParaRPr lang="en-GB" sz="14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4D823FA-BA04-4590-8D42-58F74DF67819}"/>
              </a:ext>
            </a:extLst>
          </p:cNvPr>
          <p:cNvSpPr txBox="1"/>
          <p:nvPr/>
        </p:nvSpPr>
        <p:spPr>
          <a:xfrm>
            <a:off x="770993" y="4822386"/>
            <a:ext cx="7601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400" dirty="0"/>
              <a:t>COL41A</a:t>
            </a:r>
            <a:endParaRPr lang="en-GB" sz="14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561FD6A-A3DB-4D01-908F-E0ADA58FE1E8}"/>
              </a:ext>
            </a:extLst>
          </p:cNvPr>
          <p:cNvSpPr txBox="1"/>
          <p:nvPr/>
        </p:nvSpPr>
        <p:spPr>
          <a:xfrm>
            <a:off x="852508" y="3146490"/>
            <a:ext cx="560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400" dirty="0"/>
              <a:t>CTGF</a:t>
            </a:r>
            <a:endParaRPr lang="en-GB" sz="14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E105891-CAC9-4FE9-8BD4-46CDFEC32DC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54011" y="893976"/>
            <a:ext cx="2015776" cy="153745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F04EA0A-923B-4C44-A6ED-0E484B2B9E7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38493" y="893975"/>
            <a:ext cx="2015776" cy="1537457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1E3AD656-7C6D-480D-B06E-D492961E2C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50567" y="2458663"/>
            <a:ext cx="2015776" cy="1537457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26B2EEA6-7877-43DB-8988-BBB0E24F007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038492" y="2458663"/>
            <a:ext cx="2015776" cy="1537457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100E8196-4595-4B6A-85C9-53C8A4A9A47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47931" y="4019907"/>
            <a:ext cx="2015776" cy="1537457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746D3626-65E2-418D-B9F3-96B31EE9348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038492" y="4023350"/>
            <a:ext cx="2015776" cy="1537457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5D36EDB0-8EAD-43F8-9427-019B19C34F4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555839" y="5579661"/>
            <a:ext cx="2015776" cy="1537457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67155031-3D3C-4937-9C05-D5D06918C95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038492" y="5581151"/>
            <a:ext cx="2015776" cy="1537457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AA40DA14-F419-4DC4-8C85-F17BD1CAB48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554924" y="7142750"/>
            <a:ext cx="2015776" cy="1537457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E926C20B-36AC-4226-B6B8-916180A84B52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038492" y="7144348"/>
            <a:ext cx="2015776" cy="1537457"/>
          </a:xfrm>
          <a:prstGeom prst="rect">
            <a:avLst/>
          </a:prstGeom>
        </p:spPr>
      </p:pic>
      <p:sp>
        <p:nvSpPr>
          <p:cNvPr id="26" name="Rectangle 25">
            <a:extLst>
              <a:ext uri="{FF2B5EF4-FFF2-40B4-BE49-F238E27FC236}">
                <a16:creationId xmlns:a16="http://schemas.microsoft.com/office/drawing/2014/main" id="{4A867042-947C-483F-8281-4863D6D1C185}"/>
              </a:ext>
            </a:extLst>
          </p:cNvPr>
          <p:cNvSpPr/>
          <p:nvPr/>
        </p:nvSpPr>
        <p:spPr>
          <a:xfrm>
            <a:off x="586872" y="8711942"/>
            <a:ext cx="5684256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t-EE" sz="11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</a:t>
            </a:r>
            <a:r>
              <a:rPr lang="et-EE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3. 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ative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crographs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f Control and DC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amples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ained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ith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API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nnective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issue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rowth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actor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CTGF),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llagen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V (COL41A) and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ytokeratin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15 (K15) are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own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cale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ar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s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200 µm.</a:t>
            </a:r>
            <a:r>
              <a:rPr lang="et-EE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en-GB" sz="1100" dirty="0"/>
          </a:p>
        </p:txBody>
      </p:sp>
    </p:spTree>
    <p:extLst>
      <p:ext uri="{BB962C8B-B14F-4D97-AF65-F5344CB8AC3E}">
        <p14:creationId xmlns:p14="http://schemas.microsoft.com/office/powerpoint/2010/main" val="260234524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>
            <a:extLst>
              <a:ext uri="{FF2B5EF4-FFF2-40B4-BE49-F238E27FC236}">
                <a16:creationId xmlns:a16="http://schemas.microsoft.com/office/drawing/2014/main" id="{7739033F-886F-41E0-A2AB-DADE5193F689}"/>
              </a:ext>
            </a:extLst>
          </p:cNvPr>
          <p:cNvSpPr txBox="1"/>
          <p:nvPr/>
        </p:nvSpPr>
        <p:spPr>
          <a:xfrm>
            <a:off x="2271442" y="632324"/>
            <a:ext cx="7251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400" dirty="0"/>
              <a:t>Control</a:t>
            </a:r>
            <a:endParaRPr lang="en-GB" sz="14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7CF5D2C-9041-4899-B629-9A9D02471DBB}"/>
              </a:ext>
            </a:extLst>
          </p:cNvPr>
          <p:cNvSpPr txBox="1"/>
          <p:nvPr/>
        </p:nvSpPr>
        <p:spPr>
          <a:xfrm>
            <a:off x="4915552" y="632323"/>
            <a:ext cx="3914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400" dirty="0"/>
              <a:t>DC</a:t>
            </a:r>
            <a:endParaRPr lang="en-GB" sz="14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AFF1456-BAF0-4A22-A1FC-B366ACE266D2}"/>
              </a:ext>
            </a:extLst>
          </p:cNvPr>
          <p:cNvSpPr txBox="1"/>
          <p:nvPr/>
        </p:nvSpPr>
        <p:spPr>
          <a:xfrm>
            <a:off x="897053" y="1563294"/>
            <a:ext cx="5346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400" dirty="0"/>
              <a:t>DAPI</a:t>
            </a:r>
            <a:endParaRPr lang="en-GB" sz="14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0E2B80A-692A-4D55-A4F1-FBBD662CF8A7}"/>
              </a:ext>
            </a:extLst>
          </p:cNvPr>
          <p:cNvSpPr txBox="1"/>
          <p:nvPr/>
        </p:nvSpPr>
        <p:spPr>
          <a:xfrm>
            <a:off x="684395" y="7839847"/>
            <a:ext cx="7562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400" dirty="0" err="1"/>
              <a:t>Merged</a:t>
            </a:r>
            <a:endParaRPr lang="en-GB" sz="14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786807C-4F97-45C0-A418-CEDDA5E1C807}"/>
              </a:ext>
            </a:extLst>
          </p:cNvPr>
          <p:cNvSpPr txBox="1"/>
          <p:nvPr/>
        </p:nvSpPr>
        <p:spPr>
          <a:xfrm>
            <a:off x="893222" y="6271962"/>
            <a:ext cx="5389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t-EE" sz="1400" dirty="0"/>
              <a:t>K15</a:t>
            </a:r>
            <a:endParaRPr lang="en-GB" sz="14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B29AE9E-566F-416B-B171-7C1FBABEDE9A}"/>
              </a:ext>
            </a:extLst>
          </p:cNvPr>
          <p:cNvSpPr txBox="1"/>
          <p:nvPr/>
        </p:nvSpPr>
        <p:spPr>
          <a:xfrm>
            <a:off x="759673" y="4676613"/>
            <a:ext cx="7601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400" dirty="0"/>
              <a:t>COL41A</a:t>
            </a:r>
            <a:endParaRPr lang="en-GB" sz="14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A4414ED-D545-472B-9BF4-05B0120B5262}"/>
              </a:ext>
            </a:extLst>
          </p:cNvPr>
          <p:cNvSpPr txBox="1"/>
          <p:nvPr/>
        </p:nvSpPr>
        <p:spPr>
          <a:xfrm>
            <a:off x="871469" y="3073041"/>
            <a:ext cx="560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400" dirty="0"/>
              <a:t>CTGF</a:t>
            </a:r>
            <a:endParaRPr lang="en-GB" sz="1400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5B57A2D1-6940-44B8-B7A3-41CEE1033FD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54923" y="877692"/>
            <a:ext cx="2023431" cy="1543295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FBFF7DD7-43D9-4559-9559-90D7F5308FE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54922" y="2455283"/>
            <a:ext cx="2023431" cy="154329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F461DF8-6A6E-4718-8819-7C92967A946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49206" y="4023169"/>
            <a:ext cx="2023431" cy="1543295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9241A5C4-0C27-4F14-B077-0C1827C2021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49207" y="5600762"/>
            <a:ext cx="2023431" cy="1543295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694FBCB8-7C62-45AD-A125-CA82C7ABCE0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49207" y="7178353"/>
            <a:ext cx="2023431" cy="1543295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2AE1C7A1-6FA1-4357-9B7C-F2BCA67A8AF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947064" y="877692"/>
            <a:ext cx="2023431" cy="1543295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C1824FF1-A183-408C-B18B-B61D26CEFE8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947063" y="2455283"/>
            <a:ext cx="2023431" cy="1543295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77EDD91E-60C7-4614-A9D4-86333BCD645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941347" y="4023169"/>
            <a:ext cx="2029147" cy="1543295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BEFBD236-603D-4B46-B4E6-744C176E14B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941347" y="5600761"/>
            <a:ext cx="2023431" cy="1543295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688CA525-393F-4AA3-8989-51BA930A87A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941347" y="7178353"/>
            <a:ext cx="2023431" cy="1543295"/>
          </a:xfrm>
          <a:prstGeom prst="rect">
            <a:avLst/>
          </a:prstGeom>
        </p:spPr>
      </p:pic>
      <p:sp>
        <p:nvSpPr>
          <p:cNvPr id="19" name="Rectangle 18">
            <a:extLst>
              <a:ext uri="{FF2B5EF4-FFF2-40B4-BE49-F238E27FC236}">
                <a16:creationId xmlns:a16="http://schemas.microsoft.com/office/drawing/2014/main" id="{24CA0A6E-AA59-4C18-8F8B-A90845942EBA}"/>
              </a:ext>
            </a:extLst>
          </p:cNvPr>
          <p:cNvSpPr/>
          <p:nvPr/>
        </p:nvSpPr>
        <p:spPr>
          <a:xfrm>
            <a:off x="586872" y="8711942"/>
            <a:ext cx="5684256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t-EE" sz="11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</a:t>
            </a:r>
            <a:r>
              <a:rPr lang="et-EE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4. 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ative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crographs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f Control and DC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amples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ained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ith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API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nnective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issue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rowth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actor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CTGF),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llagen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V (COL41A) and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ytokeratin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15 (K15) are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own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cale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ar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s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50 µm.</a:t>
            </a:r>
            <a:r>
              <a:rPr lang="et-EE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en-GB" sz="1100" dirty="0"/>
          </a:p>
        </p:txBody>
      </p:sp>
    </p:spTree>
    <p:extLst>
      <p:ext uri="{BB962C8B-B14F-4D97-AF65-F5344CB8AC3E}">
        <p14:creationId xmlns:p14="http://schemas.microsoft.com/office/powerpoint/2010/main" val="109665339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>
            <a:extLst>
              <a:ext uri="{FF2B5EF4-FFF2-40B4-BE49-F238E27FC236}">
                <a16:creationId xmlns:a16="http://schemas.microsoft.com/office/drawing/2014/main" id="{7739033F-886F-41E0-A2AB-DADE5193F689}"/>
              </a:ext>
            </a:extLst>
          </p:cNvPr>
          <p:cNvSpPr txBox="1"/>
          <p:nvPr/>
        </p:nvSpPr>
        <p:spPr>
          <a:xfrm>
            <a:off x="2271442" y="632324"/>
            <a:ext cx="7251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400" dirty="0"/>
              <a:t>Control</a:t>
            </a:r>
            <a:endParaRPr lang="en-GB" sz="14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7CF5D2C-9041-4899-B629-9A9D02471DBB}"/>
              </a:ext>
            </a:extLst>
          </p:cNvPr>
          <p:cNvSpPr txBox="1"/>
          <p:nvPr/>
        </p:nvSpPr>
        <p:spPr>
          <a:xfrm>
            <a:off x="4583171" y="564289"/>
            <a:ext cx="3914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400" dirty="0"/>
              <a:t>DC</a:t>
            </a:r>
            <a:endParaRPr lang="en-GB" sz="14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AFF1456-BAF0-4A22-A1FC-B366ACE266D2}"/>
              </a:ext>
            </a:extLst>
          </p:cNvPr>
          <p:cNvSpPr txBox="1"/>
          <p:nvPr/>
        </p:nvSpPr>
        <p:spPr>
          <a:xfrm>
            <a:off x="897053" y="1563294"/>
            <a:ext cx="5346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400" dirty="0"/>
              <a:t>DAPI</a:t>
            </a:r>
            <a:endParaRPr lang="en-GB" sz="14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0E2B80A-692A-4D55-A4F1-FBBD662CF8A7}"/>
              </a:ext>
            </a:extLst>
          </p:cNvPr>
          <p:cNvSpPr txBox="1"/>
          <p:nvPr/>
        </p:nvSpPr>
        <p:spPr>
          <a:xfrm>
            <a:off x="649256" y="6630707"/>
            <a:ext cx="7562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400" dirty="0" err="1"/>
              <a:t>Merged</a:t>
            </a:r>
            <a:endParaRPr lang="en-GB" sz="14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786807C-4F97-45C0-A418-CEDDA5E1C807}"/>
              </a:ext>
            </a:extLst>
          </p:cNvPr>
          <p:cNvSpPr txBox="1"/>
          <p:nvPr/>
        </p:nvSpPr>
        <p:spPr>
          <a:xfrm>
            <a:off x="838721" y="4991074"/>
            <a:ext cx="5389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t-EE" sz="1400" dirty="0"/>
              <a:t>K15</a:t>
            </a:r>
            <a:endParaRPr lang="en-GB" sz="14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B29AE9E-566F-416B-B171-7C1FBABEDE9A}"/>
              </a:ext>
            </a:extLst>
          </p:cNvPr>
          <p:cNvSpPr txBox="1"/>
          <p:nvPr/>
        </p:nvSpPr>
        <p:spPr>
          <a:xfrm>
            <a:off x="848671" y="3334416"/>
            <a:ext cx="5068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400" dirty="0"/>
              <a:t>DCN</a:t>
            </a:r>
            <a:endParaRPr lang="en-GB" sz="1400" dirty="0"/>
          </a:p>
        </p:txBody>
      </p:sp>
      <p:pic>
        <p:nvPicPr>
          <p:cNvPr id="47" name="Picture 46">
            <a:extLst>
              <a:ext uri="{FF2B5EF4-FFF2-40B4-BE49-F238E27FC236}">
                <a16:creationId xmlns:a16="http://schemas.microsoft.com/office/drawing/2014/main" id="{80E02530-013A-4C1C-9390-CFC63F286F5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31751" y="882660"/>
            <a:ext cx="2158171" cy="1646063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D49612DD-4A09-411A-9E66-75FCE8E85B3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31750" y="2590077"/>
            <a:ext cx="2158171" cy="1646063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7F5C69AF-9E72-4306-815D-2E64CA5977B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431750" y="6047353"/>
            <a:ext cx="2158171" cy="1646063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1473E0D2-CBDE-42AF-8774-4A18995410D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431750" y="4318715"/>
            <a:ext cx="2158171" cy="1646063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3E702FCE-2A4D-46D1-A094-3526AC3F78D0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707026" y="872066"/>
            <a:ext cx="2158171" cy="1639966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4AFE9D66-745A-47E2-B638-D0CC5FB99704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707026" y="6047353"/>
            <a:ext cx="2164268" cy="1646063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4E76B534-9C38-4040-B1C7-FDD50B809C8E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707026" y="4318715"/>
            <a:ext cx="2164268" cy="1646063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78CE3A2A-09AB-46E1-982D-77DACD71FDC5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707026" y="2590076"/>
            <a:ext cx="2164268" cy="1646063"/>
          </a:xfrm>
          <a:prstGeom prst="rect">
            <a:avLst/>
          </a:prstGeom>
        </p:spPr>
      </p:pic>
      <p:sp>
        <p:nvSpPr>
          <p:cNvPr id="16" name="Rectangle 15">
            <a:extLst>
              <a:ext uri="{FF2B5EF4-FFF2-40B4-BE49-F238E27FC236}">
                <a16:creationId xmlns:a16="http://schemas.microsoft.com/office/drawing/2014/main" id="{2469F4F1-6294-4E62-819D-742DD1C6E819}"/>
              </a:ext>
            </a:extLst>
          </p:cNvPr>
          <p:cNvSpPr/>
          <p:nvPr/>
        </p:nvSpPr>
        <p:spPr>
          <a:xfrm>
            <a:off x="586872" y="8711942"/>
            <a:ext cx="5684256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t-EE" sz="11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</a:t>
            </a:r>
            <a:r>
              <a:rPr lang="et-EE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5. 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ative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crographs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f Control and DC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amples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ained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ith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API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ecorin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DCN) and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ytokeratin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15 (K15) are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own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cale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ar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t-E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s</a:t>
            </a:r>
            <a:r>
              <a:rPr lang="et-E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200 µm.</a:t>
            </a:r>
            <a:r>
              <a:rPr lang="et-EE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en-GB" sz="1100" dirty="0"/>
          </a:p>
        </p:txBody>
      </p:sp>
    </p:spTree>
    <p:extLst>
      <p:ext uri="{BB962C8B-B14F-4D97-AF65-F5344CB8AC3E}">
        <p14:creationId xmlns:p14="http://schemas.microsoft.com/office/powerpoint/2010/main" val="5135818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10</TotalTime>
  <Words>818</Words>
  <Application>Microsoft Office PowerPoint</Application>
  <PresentationFormat>A4 Paper (210x297 mm)</PresentationFormat>
  <Paragraphs>267</Paragraphs>
  <Slides>1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laudia Griselda Cárdenas León</dc:creator>
  <cp:lastModifiedBy>Claudia Cardenas</cp:lastModifiedBy>
  <cp:revision>102</cp:revision>
  <dcterms:created xsi:type="dcterms:W3CDTF">2022-09-21T10:28:07Z</dcterms:created>
  <dcterms:modified xsi:type="dcterms:W3CDTF">2023-01-04T11:44:04Z</dcterms:modified>
</cp:coreProperties>
</file>